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57" r:id="rId2"/>
    <p:sldId id="261" r:id="rId3"/>
    <p:sldId id="259" r:id="rId4"/>
    <p:sldId id="264" r:id="rId5"/>
    <p:sldId id="265" r:id="rId6"/>
    <p:sldId id="270" r:id="rId7"/>
    <p:sldId id="271" r:id="rId8"/>
  </p:sldIdLst>
  <p:sldSz cx="6858000" cy="9906000" type="A4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8" userDrawn="1">
          <p15:clr>
            <a:srgbClr val="A4A3A4"/>
          </p15:clr>
        </p15:guide>
        <p15:guide id="2" pos="336" userDrawn="1">
          <p15:clr>
            <a:srgbClr val="A4A3A4"/>
          </p15:clr>
        </p15:guide>
        <p15:guide id="3" pos="3952" userDrawn="1">
          <p15:clr>
            <a:srgbClr val="A4A3A4"/>
          </p15:clr>
        </p15:guide>
        <p15:guide id="4" orient="horz" pos="5864" userDrawn="1">
          <p15:clr>
            <a:srgbClr val="A4A3A4"/>
          </p15:clr>
        </p15:guide>
        <p15:guide id="6" orient="horz" pos="2394" userDrawn="1">
          <p15:clr>
            <a:srgbClr val="A4A3A4"/>
          </p15:clr>
        </p15:guide>
        <p15:guide id="7" orient="horz" pos="4104" userDrawn="1">
          <p15:clr>
            <a:srgbClr val="A4A3A4"/>
          </p15:clr>
        </p15:guide>
        <p15:guide id="8" orient="horz" pos="5592" userDrawn="1">
          <p15:clr>
            <a:srgbClr val="A4A3A4"/>
          </p15:clr>
        </p15:guide>
        <p15:guide id="9" orient="horz" pos="3007" userDrawn="1">
          <p15:clr>
            <a:srgbClr val="A4A3A4"/>
          </p15:clr>
        </p15:guide>
        <p15:guide id="10" orient="horz" pos="3192" userDrawn="1">
          <p15:clr>
            <a:srgbClr val="A4A3A4"/>
          </p15:clr>
        </p15:guide>
        <p15:guide id="11" pos="456" userDrawn="1">
          <p15:clr>
            <a:srgbClr val="A4A3A4"/>
          </p15:clr>
        </p15:guide>
        <p15:guide id="12" orient="horz" pos="2712" userDrawn="1">
          <p15:clr>
            <a:srgbClr val="A4A3A4"/>
          </p15:clr>
        </p15:guide>
        <p15:guide id="13" orient="horz" pos="1848" userDrawn="1">
          <p15:clr>
            <a:srgbClr val="A4A3A4"/>
          </p15:clr>
        </p15:guide>
        <p15:guide id="14" orient="horz" pos="528" userDrawn="1">
          <p15:clr>
            <a:srgbClr val="A4A3A4"/>
          </p15:clr>
        </p15:guide>
        <p15:guide id="15" orient="horz" pos="1608" userDrawn="1">
          <p15:clr>
            <a:srgbClr val="A4A3A4"/>
          </p15:clr>
        </p15:guide>
        <p15:guide id="16" orient="horz" pos="5728" userDrawn="1">
          <p15:clr>
            <a:srgbClr val="A4A3A4"/>
          </p15:clr>
        </p15:guide>
        <p15:guide id="17" orient="horz" pos="4464" userDrawn="1">
          <p15:clr>
            <a:srgbClr val="A4A3A4"/>
          </p15:clr>
        </p15:guide>
        <p15:guide id="18" orient="horz" pos="2160" userDrawn="1">
          <p15:clr>
            <a:srgbClr val="A4A3A4"/>
          </p15:clr>
        </p15:guide>
        <p15:guide id="19" orient="horz" pos="625" userDrawn="1">
          <p15:clr>
            <a:srgbClr val="A4A3A4"/>
          </p15:clr>
        </p15:guide>
        <p15:guide id="20" orient="horz" pos="4392" userDrawn="1">
          <p15:clr>
            <a:srgbClr val="A4A3A4"/>
          </p15:clr>
        </p15:guide>
        <p15:guide id="21" orient="horz" pos="3816" userDrawn="1">
          <p15:clr>
            <a:srgbClr val="A4A3A4"/>
          </p15:clr>
        </p15:guide>
        <p15:guide id="22" pos="3022" userDrawn="1">
          <p15:clr>
            <a:srgbClr val="A4A3A4"/>
          </p15:clr>
        </p15:guide>
        <p15:guide id="23" pos="3768" userDrawn="1">
          <p15:clr>
            <a:srgbClr val="A4A3A4"/>
          </p15:clr>
        </p15:guide>
        <p15:guide id="24" pos="13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3C3C3C"/>
    <a:srgbClr val="5252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956" autoAdjust="0"/>
    <p:restoredTop sz="94675"/>
  </p:normalViewPr>
  <p:slideViewPr>
    <p:cSldViewPr snapToGrid="0">
      <p:cViewPr varScale="1">
        <p:scale>
          <a:sx n="129" d="100"/>
          <a:sy n="129" d="100"/>
        </p:scale>
        <p:origin x="3632" y="208"/>
      </p:cViewPr>
      <p:guideLst>
        <p:guide orient="horz" pos="398"/>
        <p:guide pos="336"/>
        <p:guide pos="3952"/>
        <p:guide orient="horz" pos="5864"/>
        <p:guide orient="horz" pos="2394"/>
        <p:guide orient="horz" pos="4104"/>
        <p:guide orient="horz" pos="5592"/>
        <p:guide orient="horz" pos="3007"/>
        <p:guide orient="horz" pos="3192"/>
        <p:guide pos="456"/>
        <p:guide orient="horz" pos="2712"/>
        <p:guide orient="horz" pos="1848"/>
        <p:guide orient="horz" pos="528"/>
        <p:guide orient="horz" pos="1608"/>
        <p:guide orient="horz" pos="5728"/>
        <p:guide orient="horz" pos="4464"/>
        <p:guide orient="horz" pos="2160"/>
        <p:guide orient="horz" pos="625"/>
        <p:guide orient="horz" pos="4392"/>
        <p:guide orient="horz" pos="3816"/>
        <p:guide pos="3022"/>
        <p:guide pos="3768"/>
        <p:guide pos="139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507821087944104"/>
          <c:y val="8.5321663855452409E-2"/>
          <c:w val="0.60621613458426127"/>
          <c:h val="0.88711795244732639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>
              <a:noFill/>
            </a:ln>
          </c:spPr>
          <c:dPt>
            <c:idx val="0"/>
            <c:bubble3D val="0"/>
            <c:explosion val="7"/>
            <c:spPr>
              <a:solidFill>
                <a:srgbClr val="FF000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7D71-4609-B3CC-FC170074D411}"/>
              </c:ext>
            </c:extLst>
          </c:dPt>
          <c:dPt>
            <c:idx val="1"/>
            <c:bubble3D val="0"/>
            <c:spPr>
              <a:solidFill>
                <a:schemeClr val="accent5">
                  <a:lumMod val="75000"/>
                </a:schemeClr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7D71-4609-B3CC-FC170074D411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7D71-4609-B3CC-FC170074D411}"/>
              </c:ext>
            </c:extLst>
          </c:dPt>
          <c:dPt>
            <c:idx val="3"/>
            <c:bubble3D val="0"/>
            <c:spPr>
              <a:gradFill rotWithShape="1">
                <a:gsLst>
                  <a:gs pos="0">
                    <a:schemeClr val="accent4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7D71-4609-B3CC-FC170074D411}"/>
              </c:ext>
            </c:extLst>
          </c:dPt>
          <c:dLbls>
            <c:dLbl>
              <c:idx val="0"/>
              <c:layout>
                <c:manualLayout>
                  <c:x val="-0.18565487604011408"/>
                  <c:y val="0.19364880781548308"/>
                </c:manualLayout>
              </c:layout>
              <c:tx>
                <c:rich>
                  <a:bodyPr/>
                  <a:lstStyle/>
                  <a:p>
                    <a:r>
                      <a:rPr 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3 </a:t>
                    </a:r>
                    <a:fld id="{EDE3D4B4-71AA-4844-96AC-9B6D52FA578D}" type="CATEGORYNAME">
                      <a:rPr lang="en-US" sz="1200" b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CATEGORY NAME]</a:t>
                    </a:fld>
                    <a:r>
                      <a:rPr 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
(</a:t>
                    </a:r>
                    <a:fld id="{880EFCC1-B8BA-4A0A-873D-947EF5CE6D5D}" type="PERCENTAGE">
                      <a:rPr lang="en-US" sz="1200" b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PERCENTAGE]</a:t>
                    </a:fld>
                    <a:r>
                      <a:rPr 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c:rich>
              </c:tx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3573011643584644"/>
                      <c:h val="0.46261012699020682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7D71-4609-B3CC-FC170074D411}"/>
                </c:ext>
              </c:extLst>
            </c:dLbl>
            <c:dLbl>
              <c:idx val="1"/>
              <c:layout>
                <c:manualLayout>
                  <c:x val="0.20626131718718316"/>
                  <c:y val="-0.20753624242016522"/>
                </c:manualLayout>
              </c:layout>
              <c:tx>
                <c:rich>
                  <a:bodyPr/>
                  <a:lstStyle/>
                  <a:p>
                    <a:r>
                      <a:rPr lang="en-US" sz="1200" b="0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4 </a:t>
                    </a:r>
                    <a:fld id="{18F26CE6-07BF-40ED-AB6E-7C532432E8D5}" type="CATEGORYNAME">
                      <a:rPr lang="en-US" sz="1100" b="0" smtClean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CATEGORY NAME]</a:t>
                    </a:fld>
                    <a:r>
                      <a:rPr lang="en-US" sz="1100" b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
(</a:t>
                    </a:r>
                    <a:fld id="{0C4670C1-EFDE-47F3-98B3-2D5036889A13}" type="PERCENTAGE">
                      <a:rPr lang="en-US" sz="1100" b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PERCENTAGE]</a:t>
                    </a:fld>
                    <a:r>
                      <a:rPr lang="en-US" sz="1100" b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c:rich>
              </c:tx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829415970885702"/>
                      <c:h val="0.40933684821016336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7D71-4609-B3CC-FC170074D41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ln>
                      <a:noFill/>
                    </a:ln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5</c:f>
              <c:strCache>
                <c:ptCount val="2"/>
                <c:pt idx="0">
                  <c:v>Up-regulated genes</c:v>
                </c:pt>
                <c:pt idx="1">
                  <c:v>Down-regulated genes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43</c:v>
                </c:pt>
                <c:pt idx="1">
                  <c:v>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D71-4609-B3CC-FC170074D411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>
              <a:alpha val="82000"/>
            </a:schemeClr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008279927561394"/>
          <c:y val="4.0936829463431308E-2"/>
          <c:w val="0.60621613458426127"/>
          <c:h val="0.88711795244732639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ignificant genes</c:v>
                </c:pt>
              </c:strCache>
            </c:strRef>
          </c:tx>
          <c:spPr>
            <a:ln>
              <a:noFill/>
            </a:ln>
          </c:spPr>
          <c:dPt>
            <c:idx val="0"/>
            <c:bubble3D val="0"/>
            <c:spPr>
              <a:solidFill>
                <a:srgbClr val="FF000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19E1-468A-8D7A-2545F0A3647F}"/>
              </c:ext>
            </c:extLst>
          </c:dPt>
          <c:dPt>
            <c:idx val="1"/>
            <c:bubble3D val="0"/>
            <c:explosion val="10"/>
            <c:spPr>
              <a:solidFill>
                <a:schemeClr val="accent5">
                  <a:lumMod val="75000"/>
                </a:schemeClr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19E1-468A-8D7A-2545F0A3647F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19E1-468A-8D7A-2545F0A3647F}"/>
              </c:ext>
            </c:extLst>
          </c:dPt>
          <c:dPt>
            <c:idx val="3"/>
            <c:bubble3D val="0"/>
            <c:spPr>
              <a:gradFill rotWithShape="1">
                <a:gsLst>
                  <a:gs pos="0">
                    <a:schemeClr val="accent4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19E1-468A-8D7A-2545F0A3647F}"/>
              </c:ext>
            </c:extLst>
          </c:dPt>
          <c:dLbls>
            <c:dLbl>
              <c:idx val="0"/>
              <c:layout>
                <c:manualLayout>
                  <c:x val="-0.15918827935975269"/>
                  <c:y val="-3.5812866831496391E-2"/>
                </c:manualLayout>
              </c:layout>
              <c:tx>
                <c:rich>
                  <a:bodyPr/>
                  <a:lstStyle/>
                  <a:p>
                    <a:r>
                      <a:rPr 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135 </a:t>
                    </a:r>
                  </a:p>
                  <a:p>
                    <a:fld id="{EDE3D4B4-71AA-4844-96AC-9B6D52FA578D}" type="CATEGORYNAME">
                      <a:rPr lang="en-US" sz="1100" b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CATEGORY NAME]</a:t>
                    </a:fld>
                    <a:r>
                      <a:rPr 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
(</a:t>
                    </a:r>
                    <a:fld id="{880EFCC1-B8BA-4A0A-873D-947EF5CE6D5D}" type="PERCENTAGE">
                      <a:rPr lang="en-US" sz="1100" b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PERCENTAGE]</a:t>
                    </a:fld>
                    <a:r>
                      <a:rPr 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c:rich>
              </c:tx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9274274037519898"/>
                      <c:h val="0.74566997838716664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19E1-468A-8D7A-2545F0A3647F}"/>
                </c:ext>
              </c:extLst>
            </c:dLbl>
            <c:dLbl>
              <c:idx val="1"/>
              <c:layout>
                <c:manualLayout>
                  <c:x val="0.25104761666475761"/>
                  <c:y val="3.6790760027537887E-2"/>
                </c:manualLayout>
              </c:layout>
              <c:tx>
                <c:rich>
                  <a:bodyPr/>
                  <a:lstStyle/>
                  <a:p>
                    <a:r>
                      <a:rPr lang="en-US" sz="1100" b="0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83 </a:t>
                    </a:r>
                    <a:fld id="{18F26CE6-07BF-40ED-AB6E-7C532432E8D5}" type="CATEGORYNAME">
                      <a:rPr lang="en-US" sz="1100" b="0" smtClean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CATEGORY NAME]</a:t>
                    </a:fld>
                    <a:r>
                      <a:rPr lang="en-US" sz="1100" b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
(</a:t>
                    </a:r>
                    <a:fld id="{0C4670C1-EFDE-47F3-98B3-2D5036889A13}" type="PERCENTAGE">
                      <a:rPr lang="en-US" sz="1100" b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PERCENTAGE]</a:t>
                    </a:fld>
                    <a:r>
                      <a:rPr lang="en-US" sz="1100" b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c:rich>
              </c:tx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715628810425853"/>
                      <c:h val="0.61853349081616638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19E1-468A-8D7A-2545F0A3647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ln>
                      <a:noFill/>
                    </a:ln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5</c:f>
              <c:strCache>
                <c:ptCount val="2"/>
                <c:pt idx="0">
                  <c:v>Up-regulated genes</c:v>
                </c:pt>
                <c:pt idx="1">
                  <c:v>Down-regulated genes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2135</c:v>
                </c:pt>
                <c:pt idx="1">
                  <c:v>20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9E1-468A-8D7A-2545F0A3647F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>
              <a:alpha val="82000"/>
            </a:schemeClr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008279927561394"/>
          <c:y val="4.0936829463431308E-2"/>
          <c:w val="0.60621613458426127"/>
          <c:h val="0.88711795244732639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ignificant genes</c:v>
                </c:pt>
              </c:strCache>
            </c:strRef>
          </c:tx>
          <c:spPr>
            <a:ln>
              <a:noFill/>
            </a:ln>
          </c:spPr>
          <c:dPt>
            <c:idx val="0"/>
            <c:bubble3D val="0"/>
            <c:spPr>
              <a:solidFill>
                <a:srgbClr val="FF000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7178-44DB-AD83-BDB41F6538DC}"/>
              </c:ext>
            </c:extLst>
          </c:dPt>
          <c:dPt>
            <c:idx val="1"/>
            <c:bubble3D val="0"/>
            <c:explosion val="10"/>
            <c:spPr>
              <a:solidFill>
                <a:schemeClr val="accent5">
                  <a:lumMod val="75000"/>
                </a:schemeClr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7178-44DB-AD83-BDB41F6538DC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7178-44DB-AD83-BDB41F6538DC}"/>
              </c:ext>
            </c:extLst>
          </c:dPt>
          <c:dPt>
            <c:idx val="3"/>
            <c:bubble3D val="0"/>
            <c:spPr>
              <a:gradFill rotWithShape="1">
                <a:gsLst>
                  <a:gs pos="0">
                    <a:schemeClr val="accent4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7178-44DB-AD83-BDB41F6538DC}"/>
              </c:ext>
            </c:extLst>
          </c:dPt>
          <c:dLbls>
            <c:dLbl>
              <c:idx val="0"/>
              <c:layout>
                <c:manualLayout>
                  <c:x val="-0.13298293631471558"/>
                  <c:y val="-2.5719732254501533E-2"/>
                </c:manualLayout>
              </c:layout>
              <c:tx>
                <c:rich>
                  <a:bodyPr/>
                  <a:lstStyle/>
                  <a:p>
                    <a:r>
                      <a:rPr 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355 </a:t>
                    </a:r>
                  </a:p>
                  <a:p>
                    <a:fld id="{EDE3D4B4-71AA-4844-96AC-9B6D52FA578D}" type="CATEGORYNAME">
                      <a:rPr lang="en-US" sz="1100" b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CATEGORY NAME]</a:t>
                    </a:fld>
                    <a:r>
                      <a:rPr 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
(</a:t>
                    </a:r>
                    <a:fld id="{880EFCC1-B8BA-4A0A-873D-947EF5CE6D5D}" type="PERCENTAGE">
                      <a:rPr lang="en-US" sz="1100" b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PERCENTAGE]</a:t>
                    </a:fld>
                    <a:r>
                      <a:rPr 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c:rich>
              </c:tx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3603732608028453"/>
                      <c:h val="0.68567726842267329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7178-44DB-AD83-BDB41F6538DC}"/>
                </c:ext>
              </c:extLst>
            </c:dLbl>
            <c:dLbl>
              <c:idx val="1"/>
              <c:layout>
                <c:manualLayout>
                  <c:x val="0.20555805064113697"/>
                  <c:y val="1.6614668161744721E-2"/>
                </c:manualLayout>
              </c:layout>
              <c:tx>
                <c:rich>
                  <a:bodyPr/>
                  <a:lstStyle/>
                  <a:p>
                    <a:r>
                      <a:rPr lang="en-US" sz="1100" b="0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51 </a:t>
                    </a:r>
                    <a:fld id="{18F26CE6-07BF-40ED-AB6E-7C532432E8D5}" type="CATEGORYNAME">
                      <a:rPr lang="en-US" sz="1100" b="0" smtClean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CATEGORY NAME]</a:t>
                    </a:fld>
                    <a:r>
                      <a:rPr lang="en-US" sz="1100" b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
(</a:t>
                    </a:r>
                    <a:fld id="{0C4670C1-EFDE-47F3-98B3-2D5036889A13}" type="PERCENTAGE">
                      <a:rPr lang="en-US" sz="1100" b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PERCENTAGE]</a:t>
                    </a:fld>
                    <a:r>
                      <a:rPr lang="en-US" sz="1200" b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c:rich>
              </c:tx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3968200109263746"/>
                      <c:h val="0.59457821175495429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7178-44DB-AD83-BDB41F6538D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ln>
                      <a:noFill/>
                    </a:ln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5</c:f>
              <c:strCache>
                <c:ptCount val="2"/>
                <c:pt idx="0">
                  <c:v>Up-regulated genes</c:v>
                </c:pt>
                <c:pt idx="1">
                  <c:v>Down-regulated genes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1355</c:v>
                </c:pt>
                <c:pt idx="1">
                  <c:v>12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178-44DB-AD83-BDB41F6538DC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>
              <a:alpha val="82000"/>
            </a:schemeClr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4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344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344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image" Target="../media/image10.emf"/><Relationship Id="rId4" Type="http://schemas.openxmlformats.org/officeDocument/2006/relationships/image" Target="../media/image1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image" Target="../media/image14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7" Type="http://schemas.openxmlformats.org/officeDocument/2006/relationships/image" Target="../media/image31.emf"/><Relationship Id="rId2" Type="http://schemas.openxmlformats.org/officeDocument/2006/relationships/image" Target="../media/image26.emf"/><Relationship Id="rId1" Type="http://schemas.openxmlformats.org/officeDocument/2006/relationships/image" Target="../media/image25.emf"/><Relationship Id="rId6" Type="http://schemas.openxmlformats.org/officeDocument/2006/relationships/image" Target="../media/image30.emf"/><Relationship Id="rId5" Type="http://schemas.openxmlformats.org/officeDocument/2006/relationships/image" Target="../media/image29.emf"/><Relationship Id="rId4" Type="http://schemas.openxmlformats.org/officeDocument/2006/relationships/image" Target="../media/image28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image" Target="../media/image33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3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3650C4-781A-874B-A55E-11BF3FD585A3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4725" y="1235075"/>
            <a:ext cx="2308225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51388"/>
            <a:ext cx="5438775" cy="38893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95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37895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8AA9ED-7C43-854E-9B0C-2E62B27E5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9588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8AA9ED-7C43-854E-9B0C-2E62B27E5AD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2921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8AA9ED-7C43-854E-9B0C-2E62B27E5AD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0325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2067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7445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5770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4337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6472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80781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7032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3465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552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3968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7817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BD1546-48D4-41DA-8779-126618EC76FD}" type="datetimeFigureOut">
              <a:rPr lang="en-GB" smtClean="0"/>
              <a:t>20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858B0D-CB89-47F8-B2DD-0FC15202D82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7917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18" Type="http://schemas.openxmlformats.org/officeDocument/2006/relationships/image" Target="../media/image7.emf"/><Relationship Id="rId3" Type="http://schemas.openxmlformats.org/officeDocument/2006/relationships/image" Target="../media/image8.png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6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oleObject" Target="../embeddings/oleObject6.bin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1.emf"/><Relationship Id="rId5" Type="http://schemas.openxmlformats.org/officeDocument/2006/relationships/oleObject" Target="../embeddings/oleObject9.bin"/><Relationship Id="rId10" Type="http://schemas.openxmlformats.org/officeDocument/2006/relationships/image" Target="../media/image13.emf"/><Relationship Id="rId4" Type="http://schemas.openxmlformats.org/officeDocument/2006/relationships/image" Target="../media/image10.emf"/><Relationship Id="rId9" Type="http://schemas.openxmlformats.org/officeDocument/2006/relationships/oleObject" Target="../embeddings/oleObject11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image" Target="../media/image22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6.png"/><Relationship Id="rId12" Type="http://schemas.openxmlformats.org/officeDocument/2006/relationships/image" Target="../media/image21.png"/><Relationship Id="rId17" Type="http://schemas.openxmlformats.org/officeDocument/2006/relationships/image" Target="../media/image24.pn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23.png"/><Relationship Id="rId1" Type="http://schemas.openxmlformats.org/officeDocument/2006/relationships/vmlDrawing" Target="../drawings/vmlDrawing3.vml"/><Relationship Id="rId6" Type="http://schemas.openxmlformats.org/officeDocument/2006/relationships/image" Target="../media/image14.emf"/><Relationship Id="rId11" Type="http://schemas.openxmlformats.org/officeDocument/2006/relationships/image" Target="../media/image20.png"/><Relationship Id="rId5" Type="http://schemas.openxmlformats.org/officeDocument/2006/relationships/oleObject" Target="../embeddings/oleObject12.bin"/><Relationship Id="rId15" Type="http://schemas.openxmlformats.org/officeDocument/2006/relationships/image" Target="../media/image15.emf"/><Relationship Id="rId10" Type="http://schemas.openxmlformats.org/officeDocument/2006/relationships/image" Target="../media/image19.png"/><Relationship Id="rId4" Type="http://schemas.openxmlformats.org/officeDocument/2006/relationships/chart" Target="../charts/chart1.xml"/><Relationship Id="rId9" Type="http://schemas.openxmlformats.org/officeDocument/2006/relationships/image" Target="../media/image18.png"/><Relationship Id="rId14" Type="http://schemas.openxmlformats.org/officeDocument/2006/relationships/oleObject" Target="../embeddings/oleObject13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13" Type="http://schemas.openxmlformats.org/officeDocument/2006/relationships/image" Target="../media/image29.emf"/><Relationship Id="rId3" Type="http://schemas.openxmlformats.org/officeDocument/2006/relationships/image" Target="../media/image32.png"/><Relationship Id="rId7" Type="http://schemas.openxmlformats.org/officeDocument/2006/relationships/image" Target="../media/image26.emf"/><Relationship Id="rId12" Type="http://schemas.openxmlformats.org/officeDocument/2006/relationships/oleObject" Target="../embeddings/oleObject18.bin"/><Relationship Id="rId17" Type="http://schemas.openxmlformats.org/officeDocument/2006/relationships/image" Target="../media/image31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20.bin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15.bin"/><Relationship Id="rId11" Type="http://schemas.openxmlformats.org/officeDocument/2006/relationships/image" Target="../media/image28.emf"/><Relationship Id="rId5" Type="http://schemas.openxmlformats.org/officeDocument/2006/relationships/image" Target="../media/image25.emf"/><Relationship Id="rId15" Type="http://schemas.openxmlformats.org/officeDocument/2006/relationships/image" Target="../media/image30.emf"/><Relationship Id="rId10" Type="http://schemas.openxmlformats.org/officeDocument/2006/relationships/oleObject" Target="../embeddings/oleObject17.bin"/><Relationship Id="rId4" Type="http://schemas.openxmlformats.org/officeDocument/2006/relationships/oleObject" Target="../embeddings/oleObject14.bin"/><Relationship Id="rId9" Type="http://schemas.openxmlformats.org/officeDocument/2006/relationships/image" Target="../media/image27.emf"/><Relationship Id="rId14" Type="http://schemas.openxmlformats.org/officeDocument/2006/relationships/oleObject" Target="../embeddings/oleObject19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3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22.bin"/><Relationship Id="rId5" Type="http://schemas.openxmlformats.org/officeDocument/2006/relationships/image" Target="../media/image33.emf"/><Relationship Id="rId4" Type="http://schemas.openxmlformats.org/officeDocument/2006/relationships/oleObject" Target="../embeddings/oleObject21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emf"/><Relationship Id="rId3" Type="http://schemas.openxmlformats.org/officeDocument/2006/relationships/image" Target="../media/image36.png"/><Relationship Id="rId7" Type="http://schemas.openxmlformats.org/officeDocument/2006/relationships/oleObject" Target="../embeddings/oleObject2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microsoft.com/office/2007/relationships/hdphoto" Target="../media/hdphoto1.wdp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1650" y="218503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62280" y="2393469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65531" y="4515900"/>
            <a:ext cx="5263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526321" y="2393468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271900" y="4515899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62280" y="573894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956" y="889174"/>
            <a:ext cx="2571507" cy="1319690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FC5727BB-30FC-4B2B-A6D5-BD2E3DE58766}"/>
              </a:ext>
            </a:extLst>
          </p:cNvPr>
          <p:cNvSpPr txBox="1"/>
          <p:nvPr/>
        </p:nvSpPr>
        <p:spPr>
          <a:xfrm>
            <a:off x="3254816" y="573894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5FA30FC-F573-47DF-942A-63F8FAACEF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8521296"/>
              </p:ext>
            </p:extLst>
          </p:nvPr>
        </p:nvGraphicFramePr>
        <p:xfrm>
          <a:off x="3252551" y="642668"/>
          <a:ext cx="3229335" cy="1822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3" name="Prism 8" r:id="rId4" imgW="4416704" imgH="2492986" progId="Prism8.Document">
                  <p:embed/>
                </p:oleObj>
              </mc:Choice>
              <mc:Fallback>
                <p:oleObj name="Prism 8" r:id="rId4" imgW="4416704" imgH="249298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52551" y="642668"/>
                        <a:ext cx="3229335" cy="1822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B9CCCEC-10E5-43CF-B801-F8CF72DF06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7607685"/>
              </p:ext>
            </p:extLst>
          </p:nvPr>
        </p:nvGraphicFramePr>
        <p:xfrm>
          <a:off x="2539969" y="2662586"/>
          <a:ext cx="2442546" cy="18625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4" name="Prism 8" r:id="rId6" imgW="3896668" imgH="2971631" progId="Prism8.Document">
                  <p:embed/>
                </p:oleObj>
              </mc:Choice>
              <mc:Fallback>
                <p:oleObj name="Prism 8" r:id="rId6" imgW="3896668" imgH="297163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539969" y="2662586"/>
                        <a:ext cx="2442546" cy="18625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C6A55A1F-C68B-472F-9946-2FFFE596DC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5438271"/>
              </p:ext>
            </p:extLst>
          </p:nvPr>
        </p:nvGraphicFramePr>
        <p:xfrm>
          <a:off x="433971" y="2688409"/>
          <a:ext cx="2480789" cy="17695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5" name="Prism 8" r:id="rId8" imgW="3494397" imgH="2492986" progId="Prism8.Document">
                  <p:embed/>
                </p:oleObj>
              </mc:Choice>
              <mc:Fallback>
                <p:oleObj name="Prism 8" r:id="rId8" imgW="3494397" imgH="249298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33971" y="2688409"/>
                        <a:ext cx="2480789" cy="17695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50899F23-7135-4F23-9515-40105BB023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4323282"/>
              </p:ext>
            </p:extLst>
          </p:nvPr>
        </p:nvGraphicFramePr>
        <p:xfrm>
          <a:off x="4612327" y="2670442"/>
          <a:ext cx="2049354" cy="17337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" name="Prism 9" r:id="rId10" imgW="3832924" imgH="3238505" progId="Prism9.Document">
                  <p:embed/>
                </p:oleObj>
              </mc:Choice>
              <mc:Fallback>
                <p:oleObj name="Prism 9" r:id="rId10" imgW="3832924" imgH="323850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612327" y="2670442"/>
                        <a:ext cx="2049354" cy="17337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3597F988-FF38-4D5D-952C-D3E89E40E7D8}"/>
              </a:ext>
            </a:extLst>
          </p:cNvPr>
          <p:cNvSpPr txBox="1"/>
          <p:nvPr/>
        </p:nvSpPr>
        <p:spPr>
          <a:xfrm>
            <a:off x="4614512" y="2396157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AA6C3091-A6DE-4B21-AD68-42ACC9F99B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4689731"/>
              </p:ext>
            </p:extLst>
          </p:nvPr>
        </p:nvGraphicFramePr>
        <p:xfrm>
          <a:off x="3404686" y="4664892"/>
          <a:ext cx="3154041" cy="22172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7" name="Prism 8" r:id="rId12" imgW="5547891" imgH="3898667" progId="Prism8.Document">
                  <p:embed/>
                </p:oleObj>
              </mc:Choice>
              <mc:Fallback>
                <p:oleObj name="Prism 8" r:id="rId12" imgW="5547891" imgH="38986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404686" y="4664892"/>
                        <a:ext cx="3154041" cy="22172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Box 38">
            <a:extLst>
              <a:ext uri="{FF2B5EF4-FFF2-40B4-BE49-F238E27FC236}">
                <a16:creationId xmlns:a16="http://schemas.microsoft.com/office/drawing/2014/main" id="{71F31503-29DC-4220-817A-182007042B5B}"/>
              </a:ext>
            </a:extLst>
          </p:cNvPr>
          <p:cNvSpPr txBox="1"/>
          <p:nvPr/>
        </p:nvSpPr>
        <p:spPr>
          <a:xfrm>
            <a:off x="462280" y="6774779"/>
            <a:ext cx="5263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130F9E8-3BBE-4DD4-A00C-AD759E6DE0F6}"/>
              </a:ext>
            </a:extLst>
          </p:cNvPr>
          <p:cNvSpPr txBox="1"/>
          <p:nvPr/>
        </p:nvSpPr>
        <p:spPr>
          <a:xfrm rot="16200000">
            <a:off x="272758" y="7514461"/>
            <a:ext cx="82681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127</a:t>
            </a:r>
            <a:endParaRPr lang="ar-JO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0E11869-1608-4CCD-B1D5-467019F2B1E5}"/>
              </a:ext>
            </a:extLst>
          </p:cNvPr>
          <p:cNvSpPr txBox="1"/>
          <p:nvPr/>
        </p:nvSpPr>
        <p:spPr>
          <a:xfrm>
            <a:off x="1131321" y="9118210"/>
            <a:ext cx="96798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ar-JO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CD7A4C7E-BD21-4859-AD4E-55AF0E79D525}"/>
              </a:ext>
            </a:extLst>
          </p:cNvPr>
          <p:cNvSpPr/>
          <p:nvPr/>
        </p:nvSpPr>
        <p:spPr>
          <a:xfrm rot="16200000">
            <a:off x="1559861" y="7700484"/>
            <a:ext cx="6783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ar-JO" sz="12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A74F6F7B-94AF-409C-8672-5B1303B62391}"/>
              </a:ext>
            </a:extLst>
          </p:cNvPr>
          <p:cNvSpPr/>
          <p:nvPr/>
        </p:nvSpPr>
        <p:spPr>
          <a:xfrm rot="16200000">
            <a:off x="1523315" y="8533556"/>
            <a:ext cx="86344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ta2</a:t>
            </a:r>
            <a:r>
              <a:rPr lang="en-US" sz="1200" i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+/fl</a:t>
            </a:r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</a:t>
            </a:r>
          </a:p>
          <a:p>
            <a:pPr algn="ctr"/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v-iCre</a:t>
            </a:r>
            <a:r>
              <a:rPr lang="en-US" sz="1200" i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 </a:t>
            </a:r>
            <a:endParaRPr lang="ar-JO" sz="1200" i="1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18D37242-67BF-43B9-8E82-CC6B9B12AA32}"/>
              </a:ext>
            </a:extLst>
          </p:cNvPr>
          <p:cNvSpPr/>
          <p:nvPr/>
        </p:nvSpPr>
        <p:spPr>
          <a:xfrm>
            <a:off x="729915" y="6906451"/>
            <a:ext cx="112402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1200" dirty="0">
                <a:solidFill>
                  <a:srgbClr val="00206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Gated on </a:t>
            </a:r>
          </a:p>
          <a:p>
            <a:pPr algn="ctr">
              <a:spcAft>
                <a:spcPts val="0"/>
              </a:spcAft>
            </a:pPr>
            <a:r>
              <a:rPr lang="en-GB" sz="1200" dirty="0">
                <a:solidFill>
                  <a:srgbClr val="00206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c-kit</a:t>
            </a:r>
            <a:r>
              <a:rPr lang="en-GB" sz="1200" baseline="30000" dirty="0">
                <a:solidFill>
                  <a:srgbClr val="00206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low</a:t>
            </a:r>
            <a:r>
              <a:rPr lang="en-GB" sz="1200" dirty="0">
                <a:solidFill>
                  <a:srgbClr val="00206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ca1</a:t>
            </a:r>
            <a:r>
              <a:rPr lang="en-GB" sz="1200" baseline="30000" dirty="0">
                <a:solidFill>
                  <a:srgbClr val="00206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low</a:t>
            </a:r>
            <a:endParaRPr lang="en-GB" sz="1200" dirty="0">
              <a:solidFill>
                <a:srgbClr val="002060"/>
              </a:solidFill>
              <a:latin typeface="Arial" panose="020B060402020202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8A8F9630-17CC-4E7A-8205-3A98102DA12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83087" y="7299792"/>
            <a:ext cx="977470" cy="1896680"/>
          </a:xfrm>
          <a:prstGeom prst="rect">
            <a:avLst/>
          </a:prstGeom>
        </p:spPr>
      </p:pic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F964764A-5F4F-4482-A0B4-086E2F1C1DAA}"/>
              </a:ext>
            </a:extLst>
          </p:cNvPr>
          <p:cNvCxnSpPr>
            <a:cxnSpLocks/>
            <a:endCxn id="43" idx="1"/>
          </p:cNvCxnSpPr>
          <p:nvPr/>
        </p:nvCxnSpPr>
        <p:spPr>
          <a:xfrm flipV="1">
            <a:off x="686164" y="8066367"/>
            <a:ext cx="1" cy="12256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716CCA4A-4A65-4E9C-A00E-311F12344FC3}"/>
              </a:ext>
            </a:extLst>
          </p:cNvPr>
          <p:cNvCxnSpPr>
            <a:cxnSpLocks/>
          </p:cNvCxnSpPr>
          <p:nvPr/>
        </p:nvCxnSpPr>
        <p:spPr>
          <a:xfrm>
            <a:off x="666604" y="9287251"/>
            <a:ext cx="500138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C90084E4-14CC-477B-A389-158075678546}"/>
              </a:ext>
            </a:extLst>
          </p:cNvPr>
          <p:cNvSpPr txBox="1"/>
          <p:nvPr/>
        </p:nvSpPr>
        <p:spPr>
          <a:xfrm>
            <a:off x="1101119" y="7375598"/>
            <a:ext cx="793854" cy="2616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43%</a:t>
            </a:r>
            <a:endParaRPr lang="ar-J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3E5C122-7CE7-4420-8286-59044B0DA79D}"/>
              </a:ext>
            </a:extLst>
          </p:cNvPr>
          <p:cNvSpPr txBox="1"/>
          <p:nvPr/>
        </p:nvSpPr>
        <p:spPr>
          <a:xfrm>
            <a:off x="488114" y="7704847"/>
            <a:ext cx="96798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LP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E86469E-89CA-480A-BF03-F5AAEBFA47E5}"/>
              </a:ext>
            </a:extLst>
          </p:cNvPr>
          <p:cNvSpPr txBox="1"/>
          <p:nvPr/>
        </p:nvSpPr>
        <p:spPr>
          <a:xfrm>
            <a:off x="1148336" y="8124114"/>
            <a:ext cx="665051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34%</a:t>
            </a:r>
            <a:endParaRPr lang="ar-J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E6DA53D-D156-4301-870D-748648F41B52}"/>
              </a:ext>
            </a:extLst>
          </p:cNvPr>
          <p:cNvSpPr txBox="1"/>
          <p:nvPr/>
        </p:nvSpPr>
        <p:spPr>
          <a:xfrm>
            <a:off x="2315230" y="6776975"/>
            <a:ext cx="5263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I)</a:t>
            </a:r>
          </a:p>
        </p:txBody>
      </p:sp>
      <p:graphicFrame>
        <p:nvGraphicFramePr>
          <p:cNvPr id="77" name="Object 76">
            <a:extLst>
              <a:ext uri="{FF2B5EF4-FFF2-40B4-BE49-F238E27FC236}">
                <a16:creationId xmlns:a16="http://schemas.microsoft.com/office/drawing/2014/main" id="{355913B6-C25E-409B-92AD-918064006E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8762632"/>
              </p:ext>
            </p:extLst>
          </p:nvPr>
        </p:nvGraphicFramePr>
        <p:xfrm>
          <a:off x="485647" y="4657929"/>
          <a:ext cx="3158305" cy="22172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8" name="Prism 8" r:id="rId15" imgW="5551132" imgH="3896867" progId="Prism8.Document">
                  <p:embed/>
                </p:oleObj>
              </mc:Choice>
              <mc:Fallback>
                <p:oleObj name="Prism 8" r:id="rId15" imgW="5551132" imgH="38968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85647" y="4657929"/>
                        <a:ext cx="3158305" cy="22172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3100251F-13B7-424E-ACA0-D4A917D8A9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7422017"/>
              </p:ext>
            </p:extLst>
          </p:nvPr>
        </p:nvGraphicFramePr>
        <p:xfrm>
          <a:off x="2304456" y="7154760"/>
          <a:ext cx="2243212" cy="20442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9" name="Prism 9" r:id="rId17" imgW="2721546" imgH="2478940" progId="Prism9.Document">
                  <p:embed/>
                </p:oleObj>
              </mc:Choice>
              <mc:Fallback>
                <p:oleObj name="Prism 9" r:id="rId17" imgW="2721546" imgH="24789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304456" y="7154760"/>
                        <a:ext cx="2243212" cy="20442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643060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9FEFEE8-CE72-4667-BF34-A4E08B6988F2}"/>
              </a:ext>
            </a:extLst>
          </p:cNvPr>
          <p:cNvSpPr txBox="1"/>
          <p:nvPr/>
        </p:nvSpPr>
        <p:spPr>
          <a:xfrm>
            <a:off x="535627" y="195451"/>
            <a:ext cx="371560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438C6AA-1C79-4E4E-BFF2-E589D69D1683}"/>
              </a:ext>
            </a:extLst>
          </p:cNvPr>
          <p:cNvSpPr txBox="1"/>
          <p:nvPr/>
        </p:nvSpPr>
        <p:spPr>
          <a:xfrm>
            <a:off x="462280" y="573894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2519D82-0329-41AF-B261-4604BD1DCDA1}"/>
              </a:ext>
            </a:extLst>
          </p:cNvPr>
          <p:cNvSpPr txBox="1"/>
          <p:nvPr/>
        </p:nvSpPr>
        <p:spPr>
          <a:xfrm>
            <a:off x="3129650" y="573894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18A19E8-CB29-4751-BCAB-E2D1C947D65B}"/>
              </a:ext>
            </a:extLst>
          </p:cNvPr>
          <p:cNvSpPr txBox="1"/>
          <p:nvPr/>
        </p:nvSpPr>
        <p:spPr>
          <a:xfrm>
            <a:off x="462280" y="2870127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7B3C6C9-DDC9-47A6-BD83-41C81B9E21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6775295"/>
              </p:ext>
            </p:extLst>
          </p:nvPr>
        </p:nvGraphicFramePr>
        <p:xfrm>
          <a:off x="562923" y="771151"/>
          <a:ext cx="3011261" cy="21521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5" name="Prism 8" r:id="rId3" imgW="4980677" imgH="3558682" progId="Prism8.Document">
                  <p:embed/>
                </p:oleObj>
              </mc:Choice>
              <mc:Fallback>
                <p:oleObj name="Prism 8" r:id="rId3" imgW="4980677" imgH="355868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62923" y="771151"/>
                        <a:ext cx="3011261" cy="21521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1FEF6AB-F1F9-4EB4-B4F6-DADBC85CFB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4799213"/>
              </p:ext>
            </p:extLst>
          </p:nvPr>
        </p:nvGraphicFramePr>
        <p:xfrm>
          <a:off x="3211538" y="838544"/>
          <a:ext cx="3011261" cy="20912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6" name="Prism 8" r:id="rId5" imgW="4988240" imgH="3463962" progId="Prism8.Document">
                  <p:embed/>
                </p:oleObj>
              </mc:Choice>
              <mc:Fallback>
                <p:oleObj name="Prism 8" r:id="rId5" imgW="4988240" imgH="346396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11538" y="838544"/>
                        <a:ext cx="3011261" cy="20912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F21A593-9BDA-4F43-B59F-1CBDE1F5FD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588234"/>
              </p:ext>
            </p:extLst>
          </p:nvPr>
        </p:nvGraphicFramePr>
        <p:xfrm>
          <a:off x="513153" y="3076553"/>
          <a:ext cx="2581180" cy="2080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7" name="Prism 8" r:id="rId7" imgW="3517085" imgH="2832972" progId="Prism8.Document">
                  <p:embed/>
                </p:oleObj>
              </mc:Choice>
              <mc:Fallback>
                <p:oleObj name="Prism 8" r:id="rId7" imgW="3517085" imgH="283297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13153" y="3076553"/>
                        <a:ext cx="2581180" cy="2080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551542CE-CE67-4061-96C1-CC6FE2492790}"/>
              </a:ext>
            </a:extLst>
          </p:cNvPr>
          <p:cNvSpPr txBox="1"/>
          <p:nvPr/>
        </p:nvSpPr>
        <p:spPr>
          <a:xfrm>
            <a:off x="2822327" y="2871271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D4C5063B-A8A1-4620-B263-4123C11E4C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0331899"/>
              </p:ext>
            </p:extLst>
          </p:nvPr>
        </p:nvGraphicFramePr>
        <p:xfrm>
          <a:off x="2998788" y="3030538"/>
          <a:ext cx="1668462" cy="1944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8" name="Prism 8" r:id="rId9" imgW="2309910" imgH="2691071" progId="Prism8.Document">
                  <p:embed/>
                </p:oleObj>
              </mc:Choice>
              <mc:Fallback>
                <p:oleObj name="Prism 8" r:id="rId9" imgW="2309910" imgH="269107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998788" y="3030538"/>
                        <a:ext cx="1668462" cy="1944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582172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58157" y="593526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642911" y="593525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21178" y="2444450"/>
            <a:ext cx="480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7660BF1-0200-4C01-B808-3F33CF1BF8DF}"/>
              </a:ext>
            </a:extLst>
          </p:cNvPr>
          <p:cNvSpPr txBox="1"/>
          <p:nvPr/>
        </p:nvSpPr>
        <p:spPr>
          <a:xfrm>
            <a:off x="501650" y="245799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F9F86878-F90E-4619-B0FA-EF075788D19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919523912"/>
              </p:ext>
            </p:extLst>
          </p:nvPr>
        </p:nvGraphicFramePr>
        <p:xfrm>
          <a:off x="131363" y="657492"/>
          <a:ext cx="2810990" cy="18432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0046936-1BBC-400B-839B-057DBB09AE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0325123"/>
              </p:ext>
            </p:extLst>
          </p:nvPr>
        </p:nvGraphicFramePr>
        <p:xfrm>
          <a:off x="2577925" y="550990"/>
          <a:ext cx="3778425" cy="26772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9" name="Prism 8" r:id="rId5" imgW="5305519" imgH="3759648" progId="Prism8.Document">
                  <p:embed/>
                </p:oleObj>
              </mc:Choice>
              <mc:Fallback>
                <p:oleObj name="Prism 8" r:id="rId5" imgW="5305519" imgH="375964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577925" y="550990"/>
                        <a:ext cx="3778425" cy="26772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6A6DEE88-7F7E-4E5C-954F-FD93FBCC4A42}"/>
              </a:ext>
            </a:extLst>
          </p:cNvPr>
          <p:cNvSpPr txBox="1"/>
          <p:nvPr/>
        </p:nvSpPr>
        <p:spPr>
          <a:xfrm>
            <a:off x="2990050" y="8942264"/>
            <a:ext cx="139566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ta2</a:t>
            </a:r>
            <a:r>
              <a:rPr lang="en-US" sz="1200" i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+/fl</a:t>
            </a:r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</a:t>
            </a:r>
          </a:p>
          <a:p>
            <a:pPr algn="ctr"/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v-iCre</a:t>
            </a:r>
            <a:r>
              <a:rPr lang="en-US" sz="1200" i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 </a:t>
            </a:r>
            <a:endParaRPr lang="ar-JO" sz="1200" i="1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B7EBDD5-4F7E-4539-BE48-7439C1E6F5A8}"/>
              </a:ext>
            </a:extLst>
          </p:cNvPr>
          <p:cNvSpPr/>
          <p:nvPr/>
        </p:nvSpPr>
        <p:spPr>
          <a:xfrm>
            <a:off x="4737071" y="8982475"/>
            <a:ext cx="6783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ar-JO" sz="12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76685D31-6532-456E-B623-46349626A1F7}"/>
              </a:ext>
            </a:extLst>
          </p:cNvPr>
          <p:cNvSpPr/>
          <p:nvPr/>
        </p:nvSpPr>
        <p:spPr>
          <a:xfrm rot="16200000">
            <a:off x="-330998" y="3360455"/>
            <a:ext cx="199069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-</a:t>
            </a:r>
          </a:p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ymphopoiesis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467BFFB-21F0-423D-A11C-4D2EE8D686B7}"/>
              </a:ext>
            </a:extLst>
          </p:cNvPr>
          <p:cNvSpPr/>
          <p:nvPr/>
        </p:nvSpPr>
        <p:spPr>
          <a:xfrm rot="16200000">
            <a:off x="-195503" y="4781559"/>
            <a:ext cx="169148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ematologic neoplasms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CB6D259-A7C2-4E12-9A61-BE5341D237C8}"/>
              </a:ext>
            </a:extLst>
          </p:cNvPr>
          <p:cNvSpPr/>
          <p:nvPr/>
        </p:nvSpPr>
        <p:spPr>
          <a:xfrm>
            <a:off x="2037724" y="3047906"/>
            <a:ext cx="683546" cy="9982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3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lm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bf1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8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cf1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3DA0CDB-D7E9-437A-AB3F-D89ECD3483DA}"/>
              </a:ext>
            </a:extLst>
          </p:cNvPr>
          <p:cNvSpPr/>
          <p:nvPr/>
        </p:nvSpPr>
        <p:spPr>
          <a:xfrm>
            <a:off x="2039751" y="3939933"/>
            <a:ext cx="851038" cy="18395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dx41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pn1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33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g5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ekhm2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el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bap1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t1a1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hx2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8sia6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m6b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B19B907E-CECA-4043-A6F4-D1A9DC1404A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7355" y="3137999"/>
            <a:ext cx="1288009" cy="822288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6810A1A1-B1D8-4BA1-81F2-84C347DC2ECB}"/>
              </a:ext>
            </a:extLst>
          </p:cNvPr>
          <p:cNvSpPr txBox="1"/>
          <p:nvPr/>
        </p:nvSpPr>
        <p:spPr>
          <a:xfrm>
            <a:off x="2840109" y="7132361"/>
            <a:ext cx="480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6A11B674-9CEB-4BCB-A5F7-E4DFD844E971}"/>
              </a:ext>
            </a:extLst>
          </p:cNvPr>
          <p:cNvSpPr/>
          <p:nvPr/>
        </p:nvSpPr>
        <p:spPr>
          <a:xfrm>
            <a:off x="1468754" y="2530247"/>
            <a:ext cx="80092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a2</a:t>
            </a:r>
            <a:r>
              <a:rPr lang="en-GB" sz="12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fl</a:t>
            </a:r>
            <a:r>
              <a:rPr lang="en-GB" sz="12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</a:p>
          <a:p>
            <a:r>
              <a:rPr lang="en-GB" sz="12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v-Cre</a:t>
            </a:r>
            <a:r>
              <a:rPr lang="en-GB" sz="1200" b="1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6D83D5A-ABC4-4223-AB76-93C9F95754AB}"/>
              </a:ext>
            </a:extLst>
          </p:cNvPr>
          <p:cNvSpPr/>
          <p:nvPr/>
        </p:nvSpPr>
        <p:spPr>
          <a:xfrm>
            <a:off x="608465" y="2632261"/>
            <a:ext cx="11465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1" name="Left Brace 30">
            <a:extLst>
              <a:ext uri="{FF2B5EF4-FFF2-40B4-BE49-F238E27FC236}">
                <a16:creationId xmlns:a16="http://schemas.microsoft.com/office/drawing/2014/main" id="{5A0C8DCF-6F61-449D-A34E-8F5700F3D009}"/>
              </a:ext>
            </a:extLst>
          </p:cNvPr>
          <p:cNvSpPr/>
          <p:nvPr/>
        </p:nvSpPr>
        <p:spPr>
          <a:xfrm rot="5400000">
            <a:off x="1048120" y="2792221"/>
            <a:ext cx="179440" cy="527367"/>
          </a:xfrm>
          <a:prstGeom prst="leftBrace">
            <a:avLst/>
          </a:prstGeom>
          <a:solidFill>
            <a:schemeClr val="bg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Left Brace 31">
            <a:extLst>
              <a:ext uri="{FF2B5EF4-FFF2-40B4-BE49-F238E27FC236}">
                <a16:creationId xmlns:a16="http://schemas.microsoft.com/office/drawing/2014/main" id="{1EBB0C84-A95B-4D1A-9005-A57D3EB30E33}"/>
              </a:ext>
            </a:extLst>
          </p:cNvPr>
          <p:cNvSpPr/>
          <p:nvPr/>
        </p:nvSpPr>
        <p:spPr>
          <a:xfrm rot="5400000">
            <a:off x="1691945" y="2790232"/>
            <a:ext cx="169826" cy="521732"/>
          </a:xfrm>
          <a:prstGeom prst="leftBrace">
            <a:avLst/>
          </a:prstGeom>
          <a:solidFill>
            <a:schemeClr val="bg1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8C866EED-662A-48A1-8243-680C52F8CCC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9589" y="3970050"/>
            <a:ext cx="1283540" cy="1778941"/>
          </a:xfrm>
          <a:prstGeom prst="rect">
            <a:avLst/>
          </a:prstGeom>
        </p:spPr>
      </p:pic>
      <p:sp>
        <p:nvSpPr>
          <p:cNvPr id="36" name="Rectangle 35">
            <a:extLst>
              <a:ext uri="{FF2B5EF4-FFF2-40B4-BE49-F238E27FC236}">
                <a16:creationId xmlns:a16="http://schemas.microsoft.com/office/drawing/2014/main" id="{AE3AEDD2-2213-474D-B783-BF412D3E8E40}"/>
              </a:ext>
            </a:extLst>
          </p:cNvPr>
          <p:cNvSpPr/>
          <p:nvPr/>
        </p:nvSpPr>
        <p:spPr>
          <a:xfrm rot="16200000">
            <a:off x="247728" y="6348561"/>
            <a:ext cx="80502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C52ACA9E-5AD1-410B-9A32-51CAE6ED0972}"/>
              </a:ext>
            </a:extLst>
          </p:cNvPr>
          <p:cNvSpPr/>
          <p:nvPr/>
        </p:nvSpPr>
        <p:spPr>
          <a:xfrm rot="16200000">
            <a:off x="152463" y="8661476"/>
            <a:ext cx="104227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ell adhesion</a:t>
            </a:r>
          </a:p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molecules 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3C9A8C43-0B5C-4401-A026-AA985709C287}"/>
              </a:ext>
            </a:extLst>
          </p:cNvPr>
          <p:cNvSpPr/>
          <p:nvPr/>
        </p:nvSpPr>
        <p:spPr>
          <a:xfrm rot="16200000">
            <a:off x="177311" y="7679566"/>
            <a:ext cx="99257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ytoskeletal </a:t>
            </a:r>
          </a:p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organizatio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E3A789D6-822A-404A-845F-23587576A135}"/>
              </a:ext>
            </a:extLst>
          </p:cNvPr>
          <p:cNvSpPr/>
          <p:nvPr/>
        </p:nvSpPr>
        <p:spPr>
          <a:xfrm>
            <a:off x="2046382" y="5694993"/>
            <a:ext cx="851038" cy="15695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imap4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k5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frsf22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xn2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ca3a1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car2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nip3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p3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ssf6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FF778954-192B-47DC-8413-47C43C682010}"/>
              </a:ext>
            </a:extLst>
          </p:cNvPr>
          <p:cNvSpPr/>
          <p:nvPr/>
        </p:nvSpPr>
        <p:spPr>
          <a:xfrm>
            <a:off x="2084420" y="8362087"/>
            <a:ext cx="851038" cy="10422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cam1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bs2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ec10a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p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p4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3511DE8C-0D06-46FD-8CCA-A4160AB8F73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34644" y="5772402"/>
            <a:ext cx="1283540" cy="1450629"/>
          </a:xfrm>
          <a:prstGeom prst="rect">
            <a:avLst/>
          </a:prstGeom>
        </p:spPr>
      </p:pic>
      <p:sp>
        <p:nvSpPr>
          <p:cNvPr id="52" name="Rectangle 51">
            <a:extLst>
              <a:ext uri="{FF2B5EF4-FFF2-40B4-BE49-F238E27FC236}">
                <a16:creationId xmlns:a16="http://schemas.microsoft.com/office/drawing/2014/main" id="{F63DBCB8-27CD-4E2C-ADE7-64BFB6035053}"/>
              </a:ext>
            </a:extLst>
          </p:cNvPr>
          <p:cNvSpPr/>
          <p:nvPr/>
        </p:nvSpPr>
        <p:spPr>
          <a:xfrm>
            <a:off x="2063592" y="7238346"/>
            <a:ext cx="729690" cy="1219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b41l3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rpprc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msap1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vl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mn2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scn1</a:t>
            </a:r>
          </a:p>
          <a:p>
            <a:r>
              <a:rPr lang="en-GB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r1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31A9C505-E9AF-4355-B11A-2BE993BDAE9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56408" y="7284764"/>
            <a:ext cx="1277964" cy="1124914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0EE8EFD4-AB2E-4A7D-9F21-3E759DDD890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77010" y="8477959"/>
            <a:ext cx="1277964" cy="805191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400CFEF5-12A7-4A2F-B50B-1D2B7734B2A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29823" y="9264107"/>
            <a:ext cx="1431679" cy="31326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C87C33D-D5FC-0BAE-5ED8-677946E612C5}"/>
              </a:ext>
            </a:extLst>
          </p:cNvPr>
          <p:cNvSpPr txBox="1"/>
          <p:nvPr/>
        </p:nvSpPr>
        <p:spPr>
          <a:xfrm>
            <a:off x="2465818" y="3148171"/>
            <a:ext cx="480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207" name="Rectangle 206">
            <a:extLst>
              <a:ext uri="{FF2B5EF4-FFF2-40B4-BE49-F238E27FC236}">
                <a16:creationId xmlns:a16="http://schemas.microsoft.com/office/drawing/2014/main" id="{2B6BD8F5-C41C-67C1-C18E-2531A604405B}"/>
              </a:ext>
            </a:extLst>
          </p:cNvPr>
          <p:cNvSpPr/>
          <p:nvPr/>
        </p:nvSpPr>
        <p:spPr>
          <a:xfrm rot="16200000">
            <a:off x="5847917" y="3842960"/>
            <a:ext cx="59663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ar-JO" sz="10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Rectangle 207">
            <a:extLst>
              <a:ext uri="{FF2B5EF4-FFF2-40B4-BE49-F238E27FC236}">
                <a16:creationId xmlns:a16="http://schemas.microsoft.com/office/drawing/2014/main" id="{AD5A3140-32DA-38C7-256E-E74BDCD4A3CA}"/>
              </a:ext>
            </a:extLst>
          </p:cNvPr>
          <p:cNvSpPr/>
          <p:nvPr/>
        </p:nvSpPr>
        <p:spPr>
          <a:xfrm rot="16200000">
            <a:off x="5813372" y="4456500"/>
            <a:ext cx="75693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ta2</a:t>
            </a:r>
            <a:r>
              <a:rPr lang="en-US" sz="1000" i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+/fl</a:t>
            </a:r>
            <a:r>
              <a:rPr lang="en-US" sz="10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</a:t>
            </a:r>
          </a:p>
          <a:p>
            <a:pPr algn="ctr"/>
            <a:r>
              <a:rPr lang="en-US" sz="10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v-iCre</a:t>
            </a:r>
            <a:r>
              <a:rPr lang="en-US" sz="1000" i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 </a:t>
            </a:r>
            <a:endParaRPr lang="ar-JO" sz="1000" i="1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9" name="Picture 208">
            <a:extLst>
              <a:ext uri="{FF2B5EF4-FFF2-40B4-BE49-F238E27FC236}">
                <a16:creationId xmlns:a16="http://schemas.microsoft.com/office/drawing/2014/main" id="{1A5E5DCB-AFF5-1403-C9FD-C22BBB21BCF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715423" y="3605645"/>
            <a:ext cx="3356309" cy="1415820"/>
          </a:xfrm>
          <a:prstGeom prst="rect">
            <a:avLst/>
          </a:prstGeom>
        </p:spPr>
      </p:pic>
      <p:sp>
        <p:nvSpPr>
          <p:cNvPr id="210" name="TextBox 209">
            <a:extLst>
              <a:ext uri="{FF2B5EF4-FFF2-40B4-BE49-F238E27FC236}">
                <a16:creationId xmlns:a16="http://schemas.microsoft.com/office/drawing/2014/main" id="{161C9725-9B58-950E-CB7B-26751C0B8B9A}"/>
              </a:ext>
            </a:extLst>
          </p:cNvPr>
          <p:cNvSpPr txBox="1"/>
          <p:nvPr/>
        </p:nvSpPr>
        <p:spPr>
          <a:xfrm rot="16200000">
            <a:off x="3206875" y="3864051"/>
            <a:ext cx="683589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P1</a:t>
            </a:r>
            <a:endParaRPr lang="ar-JO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6881169A-1019-E2C2-5E88-327AD08CC9C0}"/>
              </a:ext>
            </a:extLst>
          </p:cNvPr>
          <p:cNvSpPr txBox="1"/>
          <p:nvPr/>
        </p:nvSpPr>
        <p:spPr>
          <a:xfrm>
            <a:off x="4672696" y="4980450"/>
            <a:ext cx="80667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ar-JO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11DC6F0A-2899-FD0F-4D4B-4A03B52077D3}"/>
              </a:ext>
            </a:extLst>
          </p:cNvPr>
          <p:cNvSpPr txBox="1"/>
          <p:nvPr/>
        </p:nvSpPr>
        <p:spPr>
          <a:xfrm>
            <a:off x="5542942" y="4984037"/>
            <a:ext cx="80667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ar-JO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6C949D55-BC61-B692-D21B-48418DCB0ABC}"/>
              </a:ext>
            </a:extLst>
          </p:cNvPr>
          <p:cNvSpPr txBox="1"/>
          <p:nvPr/>
        </p:nvSpPr>
        <p:spPr>
          <a:xfrm>
            <a:off x="2896231" y="4956413"/>
            <a:ext cx="806674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endParaRPr lang="ar-JO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6B283155-92A0-AF26-4C79-A9972D29984E}"/>
              </a:ext>
            </a:extLst>
          </p:cNvPr>
          <p:cNvSpPr txBox="1"/>
          <p:nvPr/>
        </p:nvSpPr>
        <p:spPr>
          <a:xfrm rot="16200000">
            <a:off x="2328377" y="3855182"/>
            <a:ext cx="683589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43</a:t>
            </a:r>
            <a:endParaRPr lang="ar-JO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56DFBF95-F296-F005-BC4E-FF0C98BE6E34}"/>
              </a:ext>
            </a:extLst>
          </p:cNvPr>
          <p:cNvSpPr txBox="1"/>
          <p:nvPr/>
        </p:nvSpPr>
        <p:spPr>
          <a:xfrm>
            <a:off x="3773612" y="4982563"/>
            <a:ext cx="542526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D19</a:t>
            </a:r>
            <a:endParaRPr lang="ar-JO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25A92C82-BA33-40FD-5B60-D332665A0CD2}"/>
              </a:ext>
            </a:extLst>
          </p:cNvPr>
          <p:cNvSpPr txBox="1"/>
          <p:nvPr/>
        </p:nvSpPr>
        <p:spPr>
          <a:xfrm rot="16200000">
            <a:off x="4071406" y="3864701"/>
            <a:ext cx="683589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endParaRPr lang="ar-JO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7E237548-23A0-A014-9484-62A26FBDC3BF}"/>
              </a:ext>
            </a:extLst>
          </p:cNvPr>
          <p:cNvSpPr txBox="1"/>
          <p:nvPr/>
        </p:nvSpPr>
        <p:spPr>
          <a:xfrm rot="16200000">
            <a:off x="4938570" y="3862375"/>
            <a:ext cx="683589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endParaRPr lang="ar-JO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A0770D3B-3E3F-B300-D124-9203DD830D5C}"/>
              </a:ext>
            </a:extLst>
          </p:cNvPr>
          <p:cNvSpPr txBox="1"/>
          <p:nvPr/>
        </p:nvSpPr>
        <p:spPr>
          <a:xfrm>
            <a:off x="2767450" y="4277145"/>
            <a:ext cx="5836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5.6% 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C2EBA91D-030F-8B2B-7B3B-D40D90D42E5B}"/>
              </a:ext>
            </a:extLst>
          </p:cNvPr>
          <p:cNvSpPr txBox="1"/>
          <p:nvPr/>
        </p:nvSpPr>
        <p:spPr>
          <a:xfrm>
            <a:off x="3077653" y="4782454"/>
            <a:ext cx="5753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0.5% 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E78D854F-8875-61C2-3C0B-CE0F75FE5238}"/>
              </a:ext>
            </a:extLst>
          </p:cNvPr>
          <p:cNvSpPr txBox="1"/>
          <p:nvPr/>
        </p:nvSpPr>
        <p:spPr>
          <a:xfrm>
            <a:off x="2708490" y="4779699"/>
            <a:ext cx="606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9.9% 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DEFC1BAD-C338-4A42-9185-91863E5072B5}"/>
              </a:ext>
            </a:extLst>
          </p:cNvPr>
          <p:cNvSpPr txBox="1"/>
          <p:nvPr/>
        </p:nvSpPr>
        <p:spPr>
          <a:xfrm>
            <a:off x="5459604" y="4291507"/>
            <a:ext cx="599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4.2% 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3A161FB6-5E95-4EF4-F60D-70080ED8E9E9}"/>
              </a:ext>
            </a:extLst>
          </p:cNvPr>
          <p:cNvSpPr txBox="1"/>
          <p:nvPr/>
        </p:nvSpPr>
        <p:spPr>
          <a:xfrm>
            <a:off x="4594052" y="4313555"/>
            <a:ext cx="5527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2.3% 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C71D711F-D777-A7D7-C7A8-83B68FC948A0}"/>
              </a:ext>
            </a:extLst>
          </p:cNvPr>
          <p:cNvSpPr txBox="1"/>
          <p:nvPr/>
        </p:nvSpPr>
        <p:spPr>
          <a:xfrm>
            <a:off x="3784219" y="4369149"/>
            <a:ext cx="5730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9.1% 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B614A28B-07AF-1EF1-2383-047768BCE5E7}"/>
              </a:ext>
            </a:extLst>
          </p:cNvPr>
          <p:cNvSpPr txBox="1"/>
          <p:nvPr/>
        </p:nvSpPr>
        <p:spPr>
          <a:xfrm>
            <a:off x="3954218" y="4751187"/>
            <a:ext cx="6106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8.1% 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E7D62FA5-6445-4FC9-72C0-C4DC424917A6}"/>
              </a:ext>
            </a:extLst>
          </p:cNvPr>
          <p:cNvSpPr txBox="1"/>
          <p:nvPr/>
        </p:nvSpPr>
        <p:spPr>
          <a:xfrm>
            <a:off x="3532369" y="4867343"/>
            <a:ext cx="5425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1.7% 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D48D03E1-B9F7-9D2B-EFA4-61854BFC3C90}"/>
              </a:ext>
            </a:extLst>
          </p:cNvPr>
          <p:cNvSpPr txBox="1"/>
          <p:nvPr/>
        </p:nvSpPr>
        <p:spPr>
          <a:xfrm>
            <a:off x="2902007" y="3573781"/>
            <a:ext cx="5821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0.3% 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A2D959FF-7146-1425-A81E-8732258B4A4E}"/>
              </a:ext>
            </a:extLst>
          </p:cNvPr>
          <p:cNvSpPr txBox="1"/>
          <p:nvPr/>
        </p:nvSpPr>
        <p:spPr>
          <a:xfrm>
            <a:off x="3059978" y="4076077"/>
            <a:ext cx="5427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1.4% 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906AF0B9-59CE-7581-BD93-C9A5A9CA328F}"/>
              </a:ext>
            </a:extLst>
          </p:cNvPr>
          <p:cNvSpPr txBox="1"/>
          <p:nvPr/>
        </p:nvSpPr>
        <p:spPr>
          <a:xfrm>
            <a:off x="2710939" y="4069758"/>
            <a:ext cx="5736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5.4% 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0D0CC550-137F-7493-3955-0F7DA2BCE895}"/>
              </a:ext>
            </a:extLst>
          </p:cNvPr>
          <p:cNvSpPr txBox="1"/>
          <p:nvPr/>
        </p:nvSpPr>
        <p:spPr>
          <a:xfrm>
            <a:off x="5428287" y="3587876"/>
            <a:ext cx="599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3.1% 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2DBF3C0C-7E3F-AF46-B39A-EBE1775F119F}"/>
              </a:ext>
            </a:extLst>
          </p:cNvPr>
          <p:cNvSpPr txBox="1"/>
          <p:nvPr/>
        </p:nvSpPr>
        <p:spPr>
          <a:xfrm>
            <a:off x="3771880" y="3653075"/>
            <a:ext cx="5730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1.8% 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382752F4-88C5-6509-C44C-EC35E9745721}"/>
              </a:ext>
            </a:extLst>
          </p:cNvPr>
          <p:cNvSpPr txBox="1"/>
          <p:nvPr/>
        </p:nvSpPr>
        <p:spPr>
          <a:xfrm>
            <a:off x="3929469" y="4048945"/>
            <a:ext cx="5527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0.3% 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F6E56028-15C5-2498-C8B9-FF12C1CD7F53}"/>
              </a:ext>
            </a:extLst>
          </p:cNvPr>
          <p:cNvSpPr txBox="1"/>
          <p:nvPr/>
        </p:nvSpPr>
        <p:spPr>
          <a:xfrm>
            <a:off x="3536957" y="4138025"/>
            <a:ext cx="5527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7.7% 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B0BD5BAB-D2DF-0D7B-F1A2-896F7FBBD53D}"/>
              </a:ext>
            </a:extLst>
          </p:cNvPr>
          <p:cNvSpPr txBox="1"/>
          <p:nvPr/>
        </p:nvSpPr>
        <p:spPr>
          <a:xfrm>
            <a:off x="4583702" y="3626588"/>
            <a:ext cx="5527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0.7% 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92ECA200-B709-2B08-5EF1-4040F04A9D58}"/>
              </a:ext>
            </a:extLst>
          </p:cNvPr>
          <p:cNvSpPr txBox="1"/>
          <p:nvPr/>
        </p:nvSpPr>
        <p:spPr>
          <a:xfrm>
            <a:off x="3548134" y="3310992"/>
            <a:ext cx="853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Gated on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IgM 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D43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96D212C3-9DE0-621A-574D-19DF0B26928A}"/>
              </a:ext>
            </a:extLst>
          </p:cNvPr>
          <p:cNvSpPr txBox="1"/>
          <p:nvPr/>
        </p:nvSpPr>
        <p:spPr>
          <a:xfrm>
            <a:off x="4339451" y="3309985"/>
            <a:ext cx="10096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Gated on 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gM 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D43 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11B32FF2-BBD5-BAE0-5640-042A78B7190F}"/>
              </a:ext>
            </a:extLst>
          </p:cNvPr>
          <p:cNvSpPr txBox="1"/>
          <p:nvPr/>
        </p:nvSpPr>
        <p:spPr>
          <a:xfrm>
            <a:off x="5274586" y="3311959"/>
            <a:ext cx="8716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Gated on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IgM 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D43 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83E12027-62ED-BBAA-3D7D-3E3ABB0D26A5}"/>
              </a:ext>
            </a:extLst>
          </p:cNvPr>
          <p:cNvSpPr txBox="1"/>
          <p:nvPr/>
        </p:nvSpPr>
        <p:spPr>
          <a:xfrm>
            <a:off x="2711709" y="3437345"/>
            <a:ext cx="953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Gated on B220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238" name="Straight Arrow Connector 237">
            <a:extLst>
              <a:ext uri="{FF2B5EF4-FFF2-40B4-BE49-F238E27FC236}">
                <a16:creationId xmlns:a16="http://schemas.microsoft.com/office/drawing/2014/main" id="{8ED78B37-8EE6-D25A-466B-4178FD744FFD}"/>
              </a:ext>
            </a:extLst>
          </p:cNvPr>
          <p:cNvCxnSpPr>
            <a:cxnSpLocks/>
          </p:cNvCxnSpPr>
          <p:nvPr/>
        </p:nvCxnSpPr>
        <p:spPr>
          <a:xfrm flipH="1" flipV="1">
            <a:off x="2668202" y="4279641"/>
            <a:ext cx="9259" cy="817199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Straight Arrow Connector 238">
            <a:extLst>
              <a:ext uri="{FF2B5EF4-FFF2-40B4-BE49-F238E27FC236}">
                <a16:creationId xmlns:a16="http://schemas.microsoft.com/office/drawing/2014/main" id="{90687666-9CC7-5412-579D-3BD806D25E8F}"/>
              </a:ext>
            </a:extLst>
          </p:cNvPr>
          <p:cNvCxnSpPr>
            <a:cxnSpLocks/>
          </p:cNvCxnSpPr>
          <p:nvPr/>
        </p:nvCxnSpPr>
        <p:spPr>
          <a:xfrm>
            <a:off x="2675087" y="5094460"/>
            <a:ext cx="295298" cy="238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Straight Arrow Connector 239">
            <a:extLst>
              <a:ext uri="{FF2B5EF4-FFF2-40B4-BE49-F238E27FC236}">
                <a16:creationId xmlns:a16="http://schemas.microsoft.com/office/drawing/2014/main" id="{2DC375F3-B15A-5498-9127-CD02F8300F39}"/>
              </a:ext>
            </a:extLst>
          </p:cNvPr>
          <p:cNvCxnSpPr>
            <a:cxnSpLocks/>
          </p:cNvCxnSpPr>
          <p:nvPr/>
        </p:nvCxnSpPr>
        <p:spPr>
          <a:xfrm flipH="1" flipV="1">
            <a:off x="3558440" y="4290081"/>
            <a:ext cx="9259" cy="817199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Straight Arrow Connector 240">
            <a:extLst>
              <a:ext uri="{FF2B5EF4-FFF2-40B4-BE49-F238E27FC236}">
                <a16:creationId xmlns:a16="http://schemas.microsoft.com/office/drawing/2014/main" id="{45B7CF34-1723-C31E-9A3B-3164C59EDEC0}"/>
              </a:ext>
            </a:extLst>
          </p:cNvPr>
          <p:cNvCxnSpPr>
            <a:cxnSpLocks/>
          </p:cNvCxnSpPr>
          <p:nvPr/>
        </p:nvCxnSpPr>
        <p:spPr>
          <a:xfrm>
            <a:off x="3565325" y="5104900"/>
            <a:ext cx="295298" cy="238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Straight Arrow Connector 241">
            <a:extLst>
              <a:ext uri="{FF2B5EF4-FFF2-40B4-BE49-F238E27FC236}">
                <a16:creationId xmlns:a16="http://schemas.microsoft.com/office/drawing/2014/main" id="{0881B97B-CD55-2DB8-A4CA-B3A7730958A1}"/>
              </a:ext>
            </a:extLst>
          </p:cNvPr>
          <p:cNvCxnSpPr>
            <a:cxnSpLocks/>
          </p:cNvCxnSpPr>
          <p:nvPr/>
        </p:nvCxnSpPr>
        <p:spPr>
          <a:xfrm flipH="1" flipV="1">
            <a:off x="4424980" y="4277145"/>
            <a:ext cx="9259" cy="817199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Straight Arrow Connector 242">
            <a:extLst>
              <a:ext uri="{FF2B5EF4-FFF2-40B4-BE49-F238E27FC236}">
                <a16:creationId xmlns:a16="http://schemas.microsoft.com/office/drawing/2014/main" id="{C14FB23F-0A45-68AD-CC45-6531D8996A1C}"/>
              </a:ext>
            </a:extLst>
          </p:cNvPr>
          <p:cNvCxnSpPr>
            <a:cxnSpLocks/>
          </p:cNvCxnSpPr>
          <p:nvPr/>
        </p:nvCxnSpPr>
        <p:spPr>
          <a:xfrm>
            <a:off x="4431865" y="5091964"/>
            <a:ext cx="295298" cy="238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4" name="Straight Arrow Connector 243">
            <a:extLst>
              <a:ext uri="{FF2B5EF4-FFF2-40B4-BE49-F238E27FC236}">
                <a16:creationId xmlns:a16="http://schemas.microsoft.com/office/drawing/2014/main" id="{116E9906-F9C1-0A72-FC55-3F66A4420136}"/>
              </a:ext>
            </a:extLst>
          </p:cNvPr>
          <p:cNvCxnSpPr>
            <a:cxnSpLocks/>
          </p:cNvCxnSpPr>
          <p:nvPr/>
        </p:nvCxnSpPr>
        <p:spPr>
          <a:xfrm flipH="1" flipV="1">
            <a:off x="5282370" y="4285202"/>
            <a:ext cx="9259" cy="817199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Straight Arrow Connector 244">
            <a:extLst>
              <a:ext uri="{FF2B5EF4-FFF2-40B4-BE49-F238E27FC236}">
                <a16:creationId xmlns:a16="http://schemas.microsoft.com/office/drawing/2014/main" id="{984A11BC-0C7E-D594-C330-0D90211980E8}"/>
              </a:ext>
            </a:extLst>
          </p:cNvPr>
          <p:cNvCxnSpPr>
            <a:cxnSpLocks/>
          </p:cNvCxnSpPr>
          <p:nvPr/>
        </p:nvCxnSpPr>
        <p:spPr>
          <a:xfrm>
            <a:off x="5289255" y="5100021"/>
            <a:ext cx="295298" cy="238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TextBox 245">
            <a:extLst>
              <a:ext uri="{FF2B5EF4-FFF2-40B4-BE49-F238E27FC236}">
                <a16:creationId xmlns:a16="http://schemas.microsoft.com/office/drawing/2014/main" id="{0D989D23-81BF-29F1-1EF9-E7D81DF44604}"/>
              </a:ext>
            </a:extLst>
          </p:cNvPr>
          <p:cNvSpPr txBox="1"/>
          <p:nvPr/>
        </p:nvSpPr>
        <p:spPr>
          <a:xfrm>
            <a:off x="2552934" y="5279453"/>
            <a:ext cx="480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graphicFrame>
        <p:nvGraphicFramePr>
          <p:cNvPr id="247" name="Object 246">
            <a:extLst>
              <a:ext uri="{FF2B5EF4-FFF2-40B4-BE49-F238E27FC236}">
                <a16:creationId xmlns:a16="http://schemas.microsoft.com/office/drawing/2014/main" id="{D47F1E0C-7ADD-853A-9BBB-924941715B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9987636"/>
              </p:ext>
            </p:extLst>
          </p:nvPr>
        </p:nvGraphicFramePr>
        <p:xfrm>
          <a:off x="2652736" y="5474827"/>
          <a:ext cx="2098675" cy="1963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0" name="Prism 10" r:id="rId14" imgW="3576508" imgH="3421888" progId="Prism10.Document">
                  <p:embed/>
                </p:oleObj>
              </mc:Choice>
              <mc:Fallback>
                <p:oleObj name="Prism 10" r:id="rId14" imgW="3576508" imgH="3421888" progId="Prism10.Document">
                  <p:embed/>
                  <p:pic>
                    <p:nvPicPr>
                      <p:cNvPr id="71" name="Object 70">
                        <a:extLst>
                          <a:ext uri="{FF2B5EF4-FFF2-40B4-BE49-F238E27FC236}">
                            <a16:creationId xmlns:a16="http://schemas.microsoft.com/office/drawing/2014/main" id="{9DF3412F-BBDB-E8F4-0A4D-E0C5F8FB6B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652736" y="5474827"/>
                        <a:ext cx="2098675" cy="1963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49" name="Picture 248">
            <a:extLst>
              <a:ext uri="{FF2B5EF4-FFF2-40B4-BE49-F238E27FC236}">
                <a16:creationId xmlns:a16="http://schemas.microsoft.com/office/drawing/2014/main" id="{D32A933B-7A1B-AE28-8B50-A8280122BC9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003428" y="7409360"/>
            <a:ext cx="2502784" cy="1603220"/>
          </a:xfrm>
          <a:prstGeom prst="rect">
            <a:avLst/>
          </a:prstGeom>
        </p:spPr>
      </p:pic>
      <p:pic>
        <p:nvPicPr>
          <p:cNvPr id="251" name="Picture 250">
            <a:extLst>
              <a:ext uri="{FF2B5EF4-FFF2-40B4-BE49-F238E27FC236}">
                <a16:creationId xmlns:a16="http://schemas.microsoft.com/office/drawing/2014/main" id="{E71B0C3E-9A9D-F011-28F7-166E2B1D144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594052" y="5662757"/>
            <a:ext cx="1744511" cy="1477104"/>
          </a:xfrm>
          <a:prstGeom prst="rect">
            <a:avLst/>
          </a:prstGeom>
        </p:spPr>
      </p:pic>
      <p:sp>
        <p:nvSpPr>
          <p:cNvPr id="252" name="TextBox 251">
            <a:extLst>
              <a:ext uri="{FF2B5EF4-FFF2-40B4-BE49-F238E27FC236}">
                <a16:creationId xmlns:a16="http://schemas.microsoft.com/office/drawing/2014/main" id="{CE5A21D8-647B-72F6-CCB4-679EB23F7BCC}"/>
              </a:ext>
            </a:extLst>
          </p:cNvPr>
          <p:cNvSpPr txBox="1"/>
          <p:nvPr/>
        </p:nvSpPr>
        <p:spPr>
          <a:xfrm>
            <a:off x="4467137" y="5282245"/>
            <a:ext cx="480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B1BEC77-2278-4980-A9E4-19247F29F82A}"/>
              </a:ext>
            </a:extLst>
          </p:cNvPr>
          <p:cNvSpPr txBox="1"/>
          <p:nvPr/>
        </p:nvSpPr>
        <p:spPr>
          <a:xfrm>
            <a:off x="4367775" y="7706249"/>
            <a:ext cx="136842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NES: 1.139</a:t>
            </a:r>
          </a:p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p-value: 0.071</a:t>
            </a:r>
          </a:p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FDR value: 0.09</a:t>
            </a:r>
          </a:p>
        </p:txBody>
      </p:sp>
    </p:spTree>
    <p:extLst>
      <p:ext uri="{BB962C8B-B14F-4D97-AF65-F5344CB8AC3E}">
        <p14:creationId xmlns:p14="http://schemas.microsoft.com/office/powerpoint/2010/main" val="27667700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E0BD525-AB01-4111-8760-887156E70B85}"/>
              </a:ext>
            </a:extLst>
          </p:cNvPr>
          <p:cNvSpPr txBox="1"/>
          <p:nvPr/>
        </p:nvSpPr>
        <p:spPr>
          <a:xfrm>
            <a:off x="501650" y="191207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D82A421-8F9F-497E-9286-93E7E9E37C08}"/>
              </a:ext>
            </a:extLst>
          </p:cNvPr>
          <p:cNvSpPr txBox="1"/>
          <p:nvPr/>
        </p:nvSpPr>
        <p:spPr>
          <a:xfrm>
            <a:off x="458157" y="593526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pic>
        <p:nvPicPr>
          <p:cNvPr id="83" name="Picture 82">
            <a:extLst>
              <a:ext uri="{FF2B5EF4-FFF2-40B4-BE49-F238E27FC236}">
                <a16:creationId xmlns:a16="http://schemas.microsoft.com/office/drawing/2014/main" id="{96E7B9D1-34D5-4B42-AA8C-4370E028A1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8664" y="903512"/>
            <a:ext cx="1919002" cy="2332989"/>
          </a:xfrm>
          <a:prstGeom prst="rect">
            <a:avLst/>
          </a:prstGeom>
        </p:spPr>
      </p:pic>
      <p:sp>
        <p:nvSpPr>
          <p:cNvPr id="84" name="TextBox 83">
            <a:extLst>
              <a:ext uri="{FF2B5EF4-FFF2-40B4-BE49-F238E27FC236}">
                <a16:creationId xmlns:a16="http://schemas.microsoft.com/office/drawing/2014/main" id="{CCD0E752-231F-4163-8F64-41C8922EC492}"/>
              </a:ext>
            </a:extLst>
          </p:cNvPr>
          <p:cNvSpPr txBox="1"/>
          <p:nvPr/>
        </p:nvSpPr>
        <p:spPr>
          <a:xfrm>
            <a:off x="2600457" y="593526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graphicFrame>
        <p:nvGraphicFramePr>
          <p:cNvPr id="85" name="Object 84">
            <a:extLst>
              <a:ext uri="{FF2B5EF4-FFF2-40B4-BE49-F238E27FC236}">
                <a16:creationId xmlns:a16="http://schemas.microsoft.com/office/drawing/2014/main" id="{B2383E9D-F8E0-4682-8F95-76C7744DF2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5187163"/>
              </p:ext>
            </p:extLst>
          </p:nvPr>
        </p:nvGraphicFramePr>
        <p:xfrm>
          <a:off x="2639283" y="812800"/>
          <a:ext cx="1958975" cy="1885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7" name="Prism 8" r:id="rId4" imgW="2591897" imgH="2495867" progId="Prism8.Document">
                  <p:embed/>
                </p:oleObj>
              </mc:Choice>
              <mc:Fallback>
                <p:oleObj name="Prism 8" r:id="rId4" imgW="2591897" imgH="24958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39283" y="812800"/>
                        <a:ext cx="1958975" cy="1885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8" name="Object 87">
            <a:extLst>
              <a:ext uri="{FF2B5EF4-FFF2-40B4-BE49-F238E27FC236}">
                <a16:creationId xmlns:a16="http://schemas.microsoft.com/office/drawing/2014/main" id="{C40966B2-8C48-4232-8904-6A1BF1335A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7659177"/>
              </p:ext>
            </p:extLst>
          </p:nvPr>
        </p:nvGraphicFramePr>
        <p:xfrm>
          <a:off x="4314968" y="848317"/>
          <a:ext cx="2345139" cy="20158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8" name="Prism 8" r:id="rId6" imgW="3164873" imgH="2721684" progId="Prism8.Document">
                  <p:embed/>
                </p:oleObj>
              </mc:Choice>
              <mc:Fallback>
                <p:oleObj name="Prism 8" r:id="rId6" imgW="3164873" imgH="272168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314968" y="848317"/>
                        <a:ext cx="2345139" cy="20158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9" name="TextBox 88">
            <a:extLst>
              <a:ext uri="{FF2B5EF4-FFF2-40B4-BE49-F238E27FC236}">
                <a16:creationId xmlns:a16="http://schemas.microsoft.com/office/drawing/2014/main" id="{1579B9F7-8456-47CB-871C-C96A9FD28E24}"/>
              </a:ext>
            </a:extLst>
          </p:cNvPr>
          <p:cNvSpPr txBox="1"/>
          <p:nvPr/>
        </p:nvSpPr>
        <p:spPr>
          <a:xfrm>
            <a:off x="4278871" y="593526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EB6A8190-E310-4AD5-989F-5DCBE2568350}"/>
              </a:ext>
            </a:extLst>
          </p:cNvPr>
          <p:cNvSpPr txBox="1"/>
          <p:nvPr/>
        </p:nvSpPr>
        <p:spPr>
          <a:xfrm>
            <a:off x="461147" y="3236501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graphicFrame>
        <p:nvGraphicFramePr>
          <p:cNvPr id="92" name="Object 91">
            <a:extLst>
              <a:ext uri="{FF2B5EF4-FFF2-40B4-BE49-F238E27FC236}">
                <a16:creationId xmlns:a16="http://schemas.microsoft.com/office/drawing/2014/main" id="{25EDECCA-C054-460A-9C46-CC7488A13E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7191377"/>
              </p:ext>
            </p:extLst>
          </p:nvPr>
        </p:nvGraphicFramePr>
        <p:xfrm>
          <a:off x="349250" y="3349625"/>
          <a:ext cx="6594475" cy="1658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9" name="Prism 9" r:id="rId8" imgW="7214239" imgH="1751789" progId="Prism9.Document">
                  <p:embed/>
                </p:oleObj>
              </mc:Choice>
              <mc:Fallback>
                <p:oleObj name="Prism 9" r:id="rId8" imgW="7214239" imgH="175178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9250" y="3349625"/>
                        <a:ext cx="6594475" cy="1658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3" name="TextBox 92">
            <a:extLst>
              <a:ext uri="{FF2B5EF4-FFF2-40B4-BE49-F238E27FC236}">
                <a16:creationId xmlns:a16="http://schemas.microsoft.com/office/drawing/2014/main" id="{85008051-0A8E-41C2-A869-A9A4E1B3B2B1}"/>
              </a:ext>
            </a:extLst>
          </p:cNvPr>
          <p:cNvSpPr txBox="1"/>
          <p:nvPr/>
        </p:nvSpPr>
        <p:spPr>
          <a:xfrm>
            <a:off x="458157" y="4953522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graphicFrame>
        <p:nvGraphicFramePr>
          <p:cNvPr id="94" name="Object 93">
            <a:extLst>
              <a:ext uri="{FF2B5EF4-FFF2-40B4-BE49-F238E27FC236}">
                <a16:creationId xmlns:a16="http://schemas.microsoft.com/office/drawing/2014/main" id="{32FE4608-E4CA-40D7-8BCF-6813F4FAFE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1588131"/>
              </p:ext>
            </p:extLst>
          </p:nvPr>
        </p:nvGraphicFramePr>
        <p:xfrm>
          <a:off x="542594" y="5167795"/>
          <a:ext cx="2514505" cy="21391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0" name="Prism 8" r:id="rId10" imgW="3924399" imgH="3338988" progId="Prism8.Document">
                  <p:embed/>
                </p:oleObj>
              </mc:Choice>
              <mc:Fallback>
                <p:oleObj name="Prism 8" r:id="rId10" imgW="3924399" imgH="333898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42594" y="5167795"/>
                        <a:ext cx="2514505" cy="21391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7" name="Object 96">
            <a:extLst>
              <a:ext uri="{FF2B5EF4-FFF2-40B4-BE49-F238E27FC236}">
                <a16:creationId xmlns:a16="http://schemas.microsoft.com/office/drawing/2014/main" id="{ACAB4263-A4B1-4F44-A21B-272A7E896E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8336311"/>
              </p:ext>
            </p:extLst>
          </p:nvPr>
        </p:nvGraphicFramePr>
        <p:xfrm>
          <a:off x="2720975" y="5099050"/>
          <a:ext cx="3549650" cy="2101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1" name="Prism 9" r:id="rId12" imgW="4162088" imgH="2465254" progId="Prism9.Document">
                  <p:embed/>
                </p:oleObj>
              </mc:Choice>
              <mc:Fallback>
                <p:oleObj name="Prism 9" r:id="rId12" imgW="4162088" imgH="246525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720975" y="5099050"/>
                        <a:ext cx="3549650" cy="2101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8" name="TextBox 97">
            <a:extLst>
              <a:ext uri="{FF2B5EF4-FFF2-40B4-BE49-F238E27FC236}">
                <a16:creationId xmlns:a16="http://schemas.microsoft.com/office/drawing/2014/main" id="{B913D362-A3E8-44CE-B1F5-D5C106FD9852}"/>
              </a:ext>
            </a:extLst>
          </p:cNvPr>
          <p:cNvSpPr txBox="1"/>
          <p:nvPr/>
        </p:nvSpPr>
        <p:spPr>
          <a:xfrm>
            <a:off x="2598298" y="4953522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</a:p>
        </p:txBody>
      </p:sp>
      <p:graphicFrame>
        <p:nvGraphicFramePr>
          <p:cNvPr id="99" name="Object 98">
            <a:extLst>
              <a:ext uri="{FF2B5EF4-FFF2-40B4-BE49-F238E27FC236}">
                <a16:creationId xmlns:a16="http://schemas.microsoft.com/office/drawing/2014/main" id="{91BEFF23-F00C-48DA-ADD0-4B77CC05BD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8035460"/>
              </p:ext>
            </p:extLst>
          </p:nvPr>
        </p:nvGraphicFramePr>
        <p:xfrm>
          <a:off x="562923" y="7306529"/>
          <a:ext cx="2646878" cy="21476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2" name="Prism 8" r:id="rId14" imgW="4207826" imgH="3415341" progId="Prism8.Document">
                  <p:embed/>
                </p:oleObj>
              </mc:Choice>
              <mc:Fallback>
                <p:oleObj name="Prism 8" r:id="rId14" imgW="4207826" imgH="341534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62923" y="7306529"/>
                        <a:ext cx="2646878" cy="21476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0" name="TextBox 99">
            <a:extLst>
              <a:ext uri="{FF2B5EF4-FFF2-40B4-BE49-F238E27FC236}">
                <a16:creationId xmlns:a16="http://schemas.microsoft.com/office/drawing/2014/main" id="{E1D88800-5A64-49DF-83F2-263FF7ADE3A7}"/>
              </a:ext>
            </a:extLst>
          </p:cNvPr>
          <p:cNvSpPr txBox="1"/>
          <p:nvPr/>
        </p:nvSpPr>
        <p:spPr>
          <a:xfrm>
            <a:off x="474354" y="7176547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02C0C55-4BA8-48A8-8973-8A3DD421DD6E}"/>
              </a:ext>
            </a:extLst>
          </p:cNvPr>
          <p:cNvSpPr txBox="1"/>
          <p:nvPr/>
        </p:nvSpPr>
        <p:spPr>
          <a:xfrm>
            <a:off x="2746504" y="7167327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graphicFrame>
        <p:nvGraphicFramePr>
          <p:cNvPr id="102" name="Object 101">
            <a:extLst>
              <a:ext uri="{FF2B5EF4-FFF2-40B4-BE49-F238E27FC236}">
                <a16:creationId xmlns:a16="http://schemas.microsoft.com/office/drawing/2014/main" id="{2F8CDAF8-84FA-495D-8349-64C905F73F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5629584"/>
              </p:ext>
            </p:extLst>
          </p:nvPr>
        </p:nvGraphicFramePr>
        <p:xfrm>
          <a:off x="2876742" y="7327872"/>
          <a:ext cx="2605209" cy="21263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3" name="Prism 8" r:id="rId16" imgW="4102666" imgH="3347992" progId="Prism8.Document">
                  <p:embed/>
                </p:oleObj>
              </mc:Choice>
              <mc:Fallback>
                <p:oleObj name="Prism 8" r:id="rId16" imgW="4102666" imgH="33479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876742" y="7327872"/>
                        <a:ext cx="2605209" cy="21263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150145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9F728FC-C8EA-487F-8751-200B1B2483D1}"/>
              </a:ext>
            </a:extLst>
          </p:cNvPr>
          <p:cNvSpPr txBox="1"/>
          <p:nvPr/>
        </p:nvSpPr>
        <p:spPr>
          <a:xfrm>
            <a:off x="474261" y="145420"/>
            <a:ext cx="34324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098D61A-5011-428B-A155-1F7D4CA6EE9A}"/>
              </a:ext>
            </a:extLst>
          </p:cNvPr>
          <p:cNvSpPr txBox="1"/>
          <p:nvPr/>
        </p:nvSpPr>
        <p:spPr>
          <a:xfrm>
            <a:off x="458157" y="593526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A1D8C6F1-590F-45CA-9D55-E05820B906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5728425"/>
              </p:ext>
            </p:extLst>
          </p:nvPr>
        </p:nvGraphicFramePr>
        <p:xfrm>
          <a:off x="458157" y="3643624"/>
          <a:ext cx="3810000" cy="30884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5" name="Prism 9" r:id="rId4" imgW="4157407" imgH="3371042" progId="Prism9.Document">
                  <p:embed/>
                </p:oleObj>
              </mc:Choice>
              <mc:Fallback>
                <p:oleObj name="Prism 9" r:id="rId4" imgW="4157407" imgH="337104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8157" y="3643624"/>
                        <a:ext cx="3810000" cy="30884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67F0F4DC-4C2B-4FC1-B585-3D6C6B1BA1E5}"/>
              </a:ext>
            </a:extLst>
          </p:cNvPr>
          <p:cNvSpPr txBox="1"/>
          <p:nvPr/>
        </p:nvSpPr>
        <p:spPr>
          <a:xfrm>
            <a:off x="458157" y="3556174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B0D3F3F-A4E2-9ABC-C1ED-5139F7FA51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9437321"/>
              </p:ext>
            </p:extLst>
          </p:nvPr>
        </p:nvGraphicFramePr>
        <p:xfrm>
          <a:off x="474261" y="715680"/>
          <a:ext cx="5269314" cy="28429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6" name="Prism 9" r:id="rId6" imgW="5902984" imgH="3184842" progId="Prism9.Document">
                  <p:embed/>
                </p:oleObj>
              </mc:Choice>
              <mc:Fallback>
                <p:oleObj name="Prism 9" r:id="rId6" imgW="5902984" imgH="318484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4261" y="715680"/>
                        <a:ext cx="5269314" cy="28429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451554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F57723D-3B33-49E9-A345-255955A7B88E}"/>
              </a:ext>
            </a:extLst>
          </p:cNvPr>
          <p:cNvSpPr txBox="1"/>
          <p:nvPr/>
        </p:nvSpPr>
        <p:spPr>
          <a:xfrm>
            <a:off x="549275" y="140573"/>
            <a:ext cx="34340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8AC2832-CFF8-4EB4-8ED5-24D856F5DF6C}"/>
              </a:ext>
            </a:extLst>
          </p:cNvPr>
          <p:cNvSpPr txBox="1"/>
          <p:nvPr/>
        </p:nvSpPr>
        <p:spPr>
          <a:xfrm>
            <a:off x="458157" y="566230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0E9AE7B-4316-4FA0-80DE-46215DD87044}"/>
              </a:ext>
            </a:extLst>
          </p:cNvPr>
          <p:cNvPicPr>
            <a:picLocks noChangeAspect="1"/>
          </p:cNvPicPr>
          <p:nvPr/>
        </p:nvPicPr>
        <p:blipFill>
          <a:blip r:embed="rId3">
            <a:duotone>
              <a:srgbClr val="4472C4">
                <a:shade val="45000"/>
                <a:satMod val="135000"/>
              </a:srgb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artisticLineDrawing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24703" y="1191468"/>
            <a:ext cx="1907434" cy="1724476"/>
          </a:xfrm>
          <a:prstGeom prst="re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E74E4277-676E-4F74-8026-CBD7221B9849}"/>
              </a:ext>
            </a:extLst>
          </p:cNvPr>
          <p:cNvSpPr/>
          <p:nvPr/>
        </p:nvSpPr>
        <p:spPr>
          <a:xfrm>
            <a:off x="4750117" y="2652850"/>
            <a:ext cx="190743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  <a:p>
            <a:r>
              <a:rPr lang="en-US" sz="1200" i="1" dirty="0">
                <a:solidFill>
                  <a:srgbClr val="FF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Gata2</a:t>
            </a:r>
            <a:r>
              <a:rPr lang="en-US" sz="1200" i="1" baseline="30000" dirty="0">
                <a:solidFill>
                  <a:srgbClr val="FF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+/fl</a:t>
            </a:r>
            <a:r>
              <a:rPr lang="en-US" sz="1200" i="1" dirty="0">
                <a:solidFill>
                  <a:srgbClr val="FF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;</a:t>
            </a:r>
          </a:p>
          <a:p>
            <a:r>
              <a:rPr lang="en-US" sz="1200" i="1" dirty="0">
                <a:solidFill>
                  <a:srgbClr val="FF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Vav-iCre</a:t>
            </a:r>
            <a:r>
              <a:rPr lang="en-US" sz="1200" i="1" baseline="30000" dirty="0">
                <a:solidFill>
                  <a:srgbClr val="FF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endParaRPr lang="ar-JO" sz="1200" i="1" dirty="0">
              <a:solidFill>
                <a:srgbClr val="FF0000"/>
              </a:solidFill>
              <a:latin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665DC9B-7207-40A0-9635-636A22F7FFD5}"/>
              </a:ext>
            </a:extLst>
          </p:cNvPr>
          <p:cNvSpPr/>
          <p:nvPr/>
        </p:nvSpPr>
        <p:spPr>
          <a:xfrm>
            <a:off x="5539339" y="814262"/>
            <a:ext cx="162170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Asxl1</a:t>
            </a:r>
            <a:r>
              <a:rPr lang="en-US" sz="1200" i="1" baseline="30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+/fl</a:t>
            </a:r>
            <a:r>
              <a:rPr lang="en-US" sz="1200" i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; </a:t>
            </a:r>
          </a:p>
          <a:p>
            <a:r>
              <a:rPr lang="en-US" sz="1200" i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Vav-iCre</a:t>
            </a:r>
            <a:r>
              <a:rPr lang="en-US" sz="1200" i="1" baseline="30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endParaRPr lang="ar-JO" sz="1200" i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792027A-C405-4DE9-B80A-5BEBC5D4E1F2}"/>
              </a:ext>
            </a:extLst>
          </p:cNvPr>
          <p:cNvSpPr/>
          <p:nvPr/>
        </p:nvSpPr>
        <p:spPr>
          <a:xfrm>
            <a:off x="3950571" y="810924"/>
            <a:ext cx="162170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i="1" dirty="0">
                <a:solidFill>
                  <a:srgbClr val="7030A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Gata2</a:t>
            </a:r>
            <a:r>
              <a:rPr lang="en-US" sz="1200" i="1" baseline="30000" dirty="0">
                <a:solidFill>
                  <a:srgbClr val="7030A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+/fl</a:t>
            </a:r>
            <a:r>
              <a:rPr lang="en-US" sz="1200" i="1" dirty="0">
                <a:solidFill>
                  <a:srgbClr val="7030A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; Asxl1</a:t>
            </a:r>
            <a:r>
              <a:rPr lang="en-US" sz="1200" i="1" baseline="30000" dirty="0">
                <a:solidFill>
                  <a:srgbClr val="7030A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+/fl</a:t>
            </a:r>
            <a:r>
              <a:rPr lang="en-US" sz="1200" i="1" dirty="0">
                <a:solidFill>
                  <a:srgbClr val="7030A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;</a:t>
            </a:r>
          </a:p>
          <a:p>
            <a:pPr algn="ctr"/>
            <a:r>
              <a:rPr lang="en-US" sz="1200" i="1" dirty="0">
                <a:solidFill>
                  <a:srgbClr val="7030A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Vav-iCre</a:t>
            </a:r>
            <a:r>
              <a:rPr lang="en-US" sz="1200" i="1" baseline="30000" dirty="0">
                <a:solidFill>
                  <a:srgbClr val="7030A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endParaRPr lang="ar-JO" sz="1200" i="1" dirty="0">
              <a:solidFill>
                <a:srgbClr val="7030A0"/>
              </a:solidFill>
              <a:latin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733E7D3-2E0B-4F3F-B652-84B863E10459}"/>
              </a:ext>
            </a:extLst>
          </p:cNvPr>
          <p:cNvSpPr/>
          <p:nvPr/>
        </p:nvSpPr>
        <p:spPr>
          <a:xfrm>
            <a:off x="4367481" y="1529575"/>
            <a:ext cx="4959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solidFill>
                  <a:srgbClr val="7030A0"/>
                </a:solidFill>
                <a:latin typeface="Arial" panose="020B0604020202020204" pitchFamily="34" charset="0"/>
              </a:rPr>
              <a:t>421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B18F41F-B816-47D4-8126-125A7E24CA86}"/>
              </a:ext>
            </a:extLst>
          </p:cNvPr>
          <p:cNvSpPr/>
          <p:nvPr/>
        </p:nvSpPr>
        <p:spPr>
          <a:xfrm>
            <a:off x="5250936" y="1526767"/>
            <a:ext cx="88554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2033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DEE29A0-7211-4C33-833F-7A03362EAEE0}"/>
              </a:ext>
            </a:extLst>
          </p:cNvPr>
          <p:cNvSpPr/>
          <p:nvPr/>
        </p:nvSpPr>
        <p:spPr>
          <a:xfrm>
            <a:off x="4859782" y="2377930"/>
            <a:ext cx="4959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solidFill>
                  <a:srgbClr val="FF0000"/>
                </a:solidFill>
                <a:latin typeface="Arial" panose="020B0604020202020204" pitchFamily="34" charset="0"/>
              </a:rPr>
              <a:t>64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7F8A508-F088-4F8D-AFBA-CE7BC4196D39}"/>
              </a:ext>
            </a:extLst>
          </p:cNvPr>
          <p:cNvSpPr/>
          <p:nvPr/>
        </p:nvSpPr>
        <p:spPr>
          <a:xfrm>
            <a:off x="4770761" y="1478224"/>
            <a:ext cx="70889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</a:rPr>
              <a:t>2139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8019E3E-B273-4419-8952-1706DEA58B0A}"/>
              </a:ext>
            </a:extLst>
          </p:cNvPr>
          <p:cNvSpPr/>
          <p:nvPr/>
        </p:nvSpPr>
        <p:spPr>
          <a:xfrm>
            <a:off x="4877221" y="1825768"/>
            <a:ext cx="4959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</a:rPr>
              <a:t>39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373C62D-ECFC-4BFD-8BBA-CEA13BFACD68}"/>
              </a:ext>
            </a:extLst>
          </p:cNvPr>
          <p:cNvSpPr/>
          <p:nvPr/>
        </p:nvSpPr>
        <p:spPr>
          <a:xfrm>
            <a:off x="5197731" y="1996748"/>
            <a:ext cx="4959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</a:rPr>
              <a:t>7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66B4713-BE16-46A8-B1C8-141EDCDD1C13}"/>
              </a:ext>
            </a:extLst>
          </p:cNvPr>
          <p:cNvSpPr/>
          <p:nvPr/>
        </p:nvSpPr>
        <p:spPr>
          <a:xfrm>
            <a:off x="4541500" y="1996748"/>
            <a:ext cx="4959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</a:rPr>
              <a:t>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274E3E4-7CAA-4FA7-8F7E-5F7FB7B0737D}"/>
              </a:ext>
            </a:extLst>
          </p:cNvPr>
          <p:cNvSpPr txBox="1"/>
          <p:nvPr/>
        </p:nvSpPr>
        <p:spPr>
          <a:xfrm>
            <a:off x="2150188" y="566230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A32F03D8-5CE5-44E1-926C-FFAD5C0EF2FB}"/>
              </a:ext>
            </a:extLst>
          </p:cNvPr>
          <p:cNvGraphicFramePr/>
          <p:nvPr/>
        </p:nvGraphicFramePr>
        <p:xfrm>
          <a:off x="1767170" y="1088893"/>
          <a:ext cx="2557949" cy="15426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4816E2DA-1222-45E9-911F-12AA6D979329}"/>
              </a:ext>
            </a:extLst>
          </p:cNvPr>
          <p:cNvGraphicFramePr/>
          <p:nvPr/>
        </p:nvGraphicFramePr>
        <p:xfrm>
          <a:off x="280103" y="1082412"/>
          <a:ext cx="2222146" cy="15490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3" name="Rectangle 22">
            <a:extLst>
              <a:ext uri="{FF2B5EF4-FFF2-40B4-BE49-F238E27FC236}">
                <a16:creationId xmlns:a16="http://schemas.microsoft.com/office/drawing/2014/main" id="{8160217D-BDD9-4B94-BD68-3AB1040192AE}"/>
              </a:ext>
            </a:extLst>
          </p:cNvPr>
          <p:cNvSpPr/>
          <p:nvPr/>
        </p:nvSpPr>
        <p:spPr>
          <a:xfrm>
            <a:off x="2428340" y="829293"/>
            <a:ext cx="150791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xl1</a:t>
            </a:r>
            <a:r>
              <a:rPr lang="en-US" sz="1200" i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+/fl</a:t>
            </a:r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Vav-iCre</a:t>
            </a:r>
            <a:r>
              <a:rPr lang="en-US" sz="1200" i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endParaRPr lang="ar-JO" sz="1200" i="1" dirty="0">
              <a:solidFill>
                <a:srgbClr val="002060"/>
              </a:solidFill>
              <a:latin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52C8B7DB-51F1-4BD9-8DE1-0D40812BF7B1}"/>
              </a:ext>
            </a:extLst>
          </p:cNvPr>
          <p:cNvSpPr/>
          <p:nvPr/>
        </p:nvSpPr>
        <p:spPr>
          <a:xfrm>
            <a:off x="643147" y="736961"/>
            <a:ext cx="162170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ta2</a:t>
            </a:r>
            <a:r>
              <a:rPr lang="en-US" sz="1200" i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+/fl</a:t>
            </a:r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Asxl1</a:t>
            </a:r>
            <a:r>
              <a:rPr lang="en-US" sz="1200" i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+/fl</a:t>
            </a:r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</a:t>
            </a:r>
          </a:p>
          <a:p>
            <a:pPr algn="ctr"/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Vav-iCre</a:t>
            </a:r>
            <a:r>
              <a:rPr lang="en-US" sz="1200" i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endParaRPr lang="ar-JO" sz="1200" i="1" dirty="0">
              <a:solidFill>
                <a:srgbClr val="002060"/>
              </a:solidFill>
              <a:latin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E123F76-E855-497E-8B38-D9403FA49ECB}"/>
              </a:ext>
            </a:extLst>
          </p:cNvPr>
          <p:cNvSpPr txBox="1"/>
          <p:nvPr/>
        </p:nvSpPr>
        <p:spPr>
          <a:xfrm>
            <a:off x="3901467" y="566230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2BC5A51-F617-46C9-A40E-7AC51226CCA6}"/>
              </a:ext>
            </a:extLst>
          </p:cNvPr>
          <p:cNvSpPr txBox="1"/>
          <p:nvPr/>
        </p:nvSpPr>
        <p:spPr>
          <a:xfrm>
            <a:off x="444013" y="3084481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D699242E-4E49-453F-5945-14EF9F1CC0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1499974"/>
              </p:ext>
            </p:extLst>
          </p:nvPr>
        </p:nvGraphicFramePr>
        <p:xfrm>
          <a:off x="708805" y="3133713"/>
          <a:ext cx="5053819" cy="6270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1" name="Prism 9" r:id="rId7" imgW="7816386" imgH="9705791" progId="Prism9.Document">
                  <p:embed/>
                </p:oleObj>
              </mc:Choice>
              <mc:Fallback>
                <p:oleObj name="Prism 9" r:id="rId7" imgW="7816386" imgH="9705791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BF3D9008-E01C-4035-A5F3-0FA4886113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08805" y="3133713"/>
                        <a:ext cx="5053819" cy="62706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016639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5EDCC57-D3D3-4897-A3B3-1439BCACB3A6}"/>
              </a:ext>
            </a:extLst>
          </p:cNvPr>
          <p:cNvSpPr txBox="1"/>
          <p:nvPr/>
        </p:nvSpPr>
        <p:spPr>
          <a:xfrm>
            <a:off x="549275" y="140573"/>
            <a:ext cx="34340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9E6A409-CE86-4C9F-BB1F-326BB7F13F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5474" y="918824"/>
            <a:ext cx="2223621" cy="1327505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52BAD9A3-91F2-4D22-8E85-99ACCAC11996}"/>
              </a:ext>
            </a:extLst>
          </p:cNvPr>
          <p:cNvSpPr/>
          <p:nvPr/>
        </p:nvSpPr>
        <p:spPr>
          <a:xfrm>
            <a:off x="1855538" y="1145661"/>
            <a:ext cx="99709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ES: 1.656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-value: 0.047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DR value: 0.023</a:t>
            </a:r>
            <a:endParaRPr lang="en-GB" sz="800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40A8265-D669-4DE2-9657-6E1A081FE4D4}"/>
              </a:ext>
            </a:extLst>
          </p:cNvPr>
          <p:cNvSpPr/>
          <p:nvPr/>
        </p:nvSpPr>
        <p:spPr>
          <a:xfrm>
            <a:off x="625975" y="2265818"/>
            <a:ext cx="1430535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a2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fl</a:t>
            </a:r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Asxl1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fl</a:t>
            </a:r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</a:p>
          <a:p>
            <a:pPr algn="ctr"/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v-iCre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endParaRPr lang="en-GB" sz="10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00AAFCD-355F-4389-A3B6-0D0603E32175}"/>
              </a:ext>
            </a:extLst>
          </p:cNvPr>
          <p:cNvSpPr/>
          <p:nvPr/>
        </p:nvSpPr>
        <p:spPr>
          <a:xfrm>
            <a:off x="2052679" y="2246307"/>
            <a:ext cx="941559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xl1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fl</a:t>
            </a:r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</a:p>
          <a:p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v-iCre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endParaRPr lang="en-GB" sz="10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DDD8E9D-3223-4299-87BC-7F5C2A9002AB}"/>
              </a:ext>
            </a:extLst>
          </p:cNvPr>
          <p:cNvSpPr txBox="1"/>
          <p:nvPr/>
        </p:nvSpPr>
        <p:spPr>
          <a:xfrm>
            <a:off x="458157" y="566230"/>
            <a:ext cx="529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CF3FB7AA-8D16-4D3A-B0EE-21E2531C2F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3900" y="2882085"/>
            <a:ext cx="2432996" cy="1551336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1C5E077E-12FE-443D-A873-9C95DB897003}"/>
              </a:ext>
            </a:extLst>
          </p:cNvPr>
          <p:cNvSpPr/>
          <p:nvPr/>
        </p:nvSpPr>
        <p:spPr>
          <a:xfrm>
            <a:off x="2062796" y="3052238"/>
            <a:ext cx="102049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ES: 1.909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-value: 0.0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DR value: 0.017</a:t>
            </a:r>
            <a:endParaRPr lang="en-GB" sz="800" dirty="0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BFC630F2-7DFB-4468-BDFE-0989637645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9782" y="4507698"/>
            <a:ext cx="2427114" cy="1552408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68B59889-C1BC-485A-BF2E-D67246868F93}"/>
              </a:ext>
            </a:extLst>
          </p:cNvPr>
          <p:cNvSpPr/>
          <p:nvPr/>
        </p:nvSpPr>
        <p:spPr>
          <a:xfrm>
            <a:off x="2170446" y="4742105"/>
            <a:ext cx="1068536" cy="4655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ES: 1.763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-value: 0.0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DR value: 0.017</a:t>
            </a:r>
            <a:endParaRPr lang="en-GB" sz="800" dirty="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3744ABDE-77C6-41FF-9977-81EDF418C9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0246" y="6133954"/>
            <a:ext cx="2422410" cy="1545879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550D543B-F390-43F7-98C0-0354ACA786DF}"/>
              </a:ext>
            </a:extLst>
          </p:cNvPr>
          <p:cNvSpPr/>
          <p:nvPr/>
        </p:nvSpPr>
        <p:spPr>
          <a:xfrm>
            <a:off x="2119449" y="6311973"/>
            <a:ext cx="116770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ES: 1.693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-value: 0.0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DR value: 0.017</a:t>
            </a:r>
            <a:endParaRPr lang="en-GB" sz="800" dirty="0"/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49A4C094-7F47-4D20-9474-5B12D813AF9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77538" y="6133954"/>
            <a:ext cx="2397619" cy="1526932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0B1A328F-6B04-44F3-898C-DF5B4C82E65F}"/>
              </a:ext>
            </a:extLst>
          </p:cNvPr>
          <p:cNvSpPr/>
          <p:nvPr/>
        </p:nvSpPr>
        <p:spPr>
          <a:xfrm>
            <a:off x="4722044" y="6318994"/>
            <a:ext cx="104768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ES: 1.527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-value: 0.0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DR value: 0.047</a:t>
            </a:r>
            <a:endParaRPr lang="en-GB" sz="800" dirty="0"/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55C5FDA7-429F-499B-ADFD-00998A9FED2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29000" y="2883234"/>
            <a:ext cx="2432996" cy="1524096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DAA96B0A-6252-45DE-9045-8122D0131CF8}"/>
              </a:ext>
            </a:extLst>
          </p:cNvPr>
          <p:cNvSpPr/>
          <p:nvPr/>
        </p:nvSpPr>
        <p:spPr>
          <a:xfrm>
            <a:off x="4854251" y="3064952"/>
            <a:ext cx="106106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ES: 1.688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-value: 0.0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DR value: 0.030</a:t>
            </a:r>
            <a:endParaRPr lang="en-GB" sz="800" dirty="0"/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B5511C36-5CE3-4812-BC34-E92A7C842FF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74506" y="4505749"/>
            <a:ext cx="2427114" cy="1520412"/>
          </a:xfrm>
          <a:prstGeom prst="rect">
            <a:avLst/>
          </a:prstGeom>
        </p:spPr>
      </p:pic>
      <p:sp>
        <p:nvSpPr>
          <p:cNvPr id="31" name="Rectangle 30">
            <a:extLst>
              <a:ext uri="{FF2B5EF4-FFF2-40B4-BE49-F238E27FC236}">
                <a16:creationId xmlns:a16="http://schemas.microsoft.com/office/drawing/2014/main" id="{E64DF05F-6416-420D-99D6-445CFB0803D6}"/>
              </a:ext>
            </a:extLst>
          </p:cNvPr>
          <p:cNvSpPr/>
          <p:nvPr/>
        </p:nvSpPr>
        <p:spPr>
          <a:xfrm>
            <a:off x="4787125" y="4679564"/>
            <a:ext cx="1074871" cy="4655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ES: 1.569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-value: 0.0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DR value: 0.051</a:t>
            </a:r>
            <a:endParaRPr lang="en-GB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F789377-5306-476E-A716-0E7D664176E3}"/>
              </a:ext>
            </a:extLst>
          </p:cNvPr>
          <p:cNvSpPr txBox="1"/>
          <p:nvPr/>
        </p:nvSpPr>
        <p:spPr>
          <a:xfrm>
            <a:off x="447133" y="2622164"/>
            <a:ext cx="553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32159717-D86E-4FE0-852D-538D2A5342AC}"/>
              </a:ext>
            </a:extLst>
          </p:cNvPr>
          <p:cNvSpPr/>
          <p:nvPr/>
        </p:nvSpPr>
        <p:spPr>
          <a:xfrm>
            <a:off x="3429000" y="7605067"/>
            <a:ext cx="138864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a2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fl</a:t>
            </a:r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Asxl1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fl</a:t>
            </a:r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</a:p>
          <a:p>
            <a:pPr algn="ctr"/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v-iCre</a:t>
            </a:r>
            <a:r>
              <a:rPr lang="en-GB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000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F57C9603-B0D8-4D3E-91D5-892284468763}"/>
              </a:ext>
            </a:extLst>
          </p:cNvPr>
          <p:cNvSpPr/>
          <p:nvPr/>
        </p:nvSpPr>
        <p:spPr>
          <a:xfrm>
            <a:off x="4947143" y="7592785"/>
            <a:ext cx="875285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a2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f</a:t>
            </a:r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</a:p>
          <a:p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v-iCre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endParaRPr lang="en-GB" sz="10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000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509BD91-ABB7-0001-468E-A94E4806FBB6}"/>
              </a:ext>
            </a:extLst>
          </p:cNvPr>
          <p:cNvSpPr/>
          <p:nvPr/>
        </p:nvSpPr>
        <p:spPr>
          <a:xfrm>
            <a:off x="803344" y="7617343"/>
            <a:ext cx="138864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a2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fl</a:t>
            </a:r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Asxl1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fl</a:t>
            </a:r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</a:p>
          <a:p>
            <a:pPr algn="ctr"/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v-iCre</a:t>
            </a:r>
            <a:r>
              <a:rPr lang="en-GB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00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00B2995-4F2A-6660-AAE9-723189E11206}"/>
              </a:ext>
            </a:extLst>
          </p:cNvPr>
          <p:cNvSpPr/>
          <p:nvPr/>
        </p:nvSpPr>
        <p:spPr>
          <a:xfrm>
            <a:off x="2321487" y="7605061"/>
            <a:ext cx="875285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a2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f</a:t>
            </a:r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</a:p>
          <a:p>
            <a:r>
              <a:rPr lang="en-GB" sz="10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v-iCre</a:t>
            </a:r>
            <a:r>
              <a:rPr lang="en-GB" sz="1000" i="1" baseline="30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endParaRPr lang="en-GB" sz="10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7500519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93</TotalTime>
  <Words>494</Words>
  <Application>Microsoft Macintosh PowerPoint</Application>
  <PresentationFormat>A4 Paper (210x297 mm)</PresentationFormat>
  <Paragraphs>202</Paragraphs>
  <Slides>7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rism 8</vt:lpstr>
      <vt:lpstr>Prism 9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ardiff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 Abdelfattah</dc:creator>
  <cp:lastModifiedBy>Boyd, Ashleigh</cp:lastModifiedBy>
  <cp:revision>251</cp:revision>
  <cp:lastPrinted>2020-01-14T15:34:44Z</cp:lastPrinted>
  <dcterms:created xsi:type="dcterms:W3CDTF">2019-10-22T12:43:41Z</dcterms:created>
  <dcterms:modified xsi:type="dcterms:W3CDTF">2024-08-20T11:59:38Z</dcterms:modified>
</cp:coreProperties>
</file>